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triona.turnbull\AppData\Local\Microsoft\Windows\INetCache\Content.Outlook\OSE1WWD0\PSMA-101%20Kinetic%20Analysis%20manuscript%20-%20plots%20DRAFT3%20(003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triona.turnbull\AppData\Local\Microsoft\Windows\INetCache\Content.Outlook\OSE1WWD0\PSMA-101%20Kinetic%20Analysis%20manuscript%20-%20plots%20DRAFT3%20(003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triona.turnbull\AppData\Local\Microsoft\Windows\INetCache\Content.Outlook\OSE1WWD0\PSMA-101%20Kinetic%20Analysis%20manuscript%20-%20plots%20DRAFT3%20(003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>
                <a:solidFill>
                  <a:schemeClr val="tx1"/>
                </a:solidFill>
              </a:rPr>
              <a:t>Cohort B</a:t>
            </a:r>
          </a:p>
        </c:rich>
      </c:tx>
      <c:layout>
        <c:manualLayout>
          <c:xMode val="edge"/>
          <c:yMode val="edge"/>
          <c:x val="1.3225253165404271E-2"/>
          <c:y val="2.266701712365525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title>
    <c:autoTitleDeleted val="0"/>
    <c:plotArea>
      <c:layout>
        <c:manualLayout>
          <c:layoutTarget val="inner"/>
          <c:xMode val="edge"/>
          <c:yMode val="edge"/>
          <c:x val="0.13120694588435614"/>
          <c:y val="0.1831574428021234"/>
          <c:w val="0.78924344563169557"/>
          <c:h val="0.68395653544531565"/>
        </c:manualLayout>
      </c:layout>
      <c:scatterChart>
        <c:scatterStyle val="lineMarker"/>
        <c:varyColors val="0"/>
        <c:ser>
          <c:idx val="0"/>
          <c:order val="0"/>
          <c:tx>
            <c:v>LN Met 1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6:$E$9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6:$F$9</c:f>
              <c:numCache>
                <c:formatCode>General</c:formatCode>
                <c:ptCount val="4"/>
                <c:pt idx="0">
                  <c:v>0.44637900000000003</c:v>
                </c:pt>
                <c:pt idx="1">
                  <c:v>3.0714800000000002</c:v>
                </c:pt>
                <c:pt idx="2">
                  <c:v>4.5922299999999998</c:v>
                </c:pt>
                <c:pt idx="3">
                  <c:v>4.59222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D87-4F84-AE6D-90B40A91FD66}"/>
            </c:ext>
          </c:extLst>
        </c:ser>
        <c:ser>
          <c:idx val="1"/>
          <c:order val="1"/>
          <c:tx>
            <c:strRef>
              <c:f>'Patlak_10-88_cohort-B-S0019'!$A$5</c:f>
              <c:strCache>
                <c:ptCount val="1"/>
                <c:pt idx="0">
                  <c:v>LN Met 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6:$A$25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6:$B$25</c:f>
              <c:numCache>
                <c:formatCode>General</c:formatCode>
                <c:ptCount val="20"/>
                <c:pt idx="0">
                  <c:v>1.65299E-2</c:v>
                </c:pt>
                <c:pt idx="1">
                  <c:v>0.115963</c:v>
                </c:pt>
                <c:pt idx="2">
                  <c:v>9.2131500000000005E-2</c:v>
                </c:pt>
                <c:pt idx="3">
                  <c:v>0.113591</c:v>
                </c:pt>
                <c:pt idx="4">
                  <c:v>0.141983</c:v>
                </c:pt>
                <c:pt idx="5">
                  <c:v>0.154081</c:v>
                </c:pt>
                <c:pt idx="6">
                  <c:v>0.167958</c:v>
                </c:pt>
                <c:pt idx="7">
                  <c:v>0.18684200000000001</c:v>
                </c:pt>
                <c:pt idx="8">
                  <c:v>0.26632099999999997</c:v>
                </c:pt>
                <c:pt idx="9">
                  <c:v>0.18804699999999999</c:v>
                </c:pt>
                <c:pt idx="10">
                  <c:v>0.25441999999999998</c:v>
                </c:pt>
                <c:pt idx="11">
                  <c:v>0.324374</c:v>
                </c:pt>
                <c:pt idx="12">
                  <c:v>0.44373200000000002</c:v>
                </c:pt>
                <c:pt idx="13">
                  <c:v>0.61208499999999999</c:v>
                </c:pt>
                <c:pt idx="14">
                  <c:v>0.78093699999999999</c:v>
                </c:pt>
                <c:pt idx="15">
                  <c:v>1.09998</c:v>
                </c:pt>
                <c:pt idx="16">
                  <c:v>1.52593</c:v>
                </c:pt>
                <c:pt idx="17">
                  <c:v>1.8104899999999999</c:v>
                </c:pt>
                <c:pt idx="18">
                  <c:v>2.9794499999999999</c:v>
                </c:pt>
                <c:pt idx="19">
                  <c:v>4.459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D87-4F84-AE6D-90B40A91FD66}"/>
            </c:ext>
          </c:extLst>
        </c:ser>
        <c:ser>
          <c:idx val="2"/>
          <c:order val="2"/>
          <c:tx>
            <c:strRef>
              <c:f>'Patlak_10-88_cohort-B-S0019'!$A$26</c:f>
              <c:strCache>
                <c:ptCount val="1"/>
                <c:pt idx="0">
                  <c:v>LN Met 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27:$A$46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27:$B$46</c:f>
              <c:numCache>
                <c:formatCode>General</c:formatCode>
                <c:ptCount val="20"/>
                <c:pt idx="0">
                  <c:v>2.8641199999999999E-2</c:v>
                </c:pt>
                <c:pt idx="1">
                  <c:v>0.17097999999999999</c:v>
                </c:pt>
                <c:pt idx="2">
                  <c:v>0.122392</c:v>
                </c:pt>
                <c:pt idx="3">
                  <c:v>0.138957</c:v>
                </c:pt>
                <c:pt idx="4">
                  <c:v>0.13578699999999999</c:v>
                </c:pt>
                <c:pt idx="5">
                  <c:v>0.149309</c:v>
                </c:pt>
                <c:pt idx="6">
                  <c:v>0.175816</c:v>
                </c:pt>
                <c:pt idx="7">
                  <c:v>0.161935</c:v>
                </c:pt>
                <c:pt idx="8">
                  <c:v>0.176368</c:v>
                </c:pt>
                <c:pt idx="9">
                  <c:v>0.21947900000000001</c:v>
                </c:pt>
                <c:pt idx="10">
                  <c:v>0.25351499999999999</c:v>
                </c:pt>
                <c:pt idx="11">
                  <c:v>0.31223200000000001</c:v>
                </c:pt>
                <c:pt idx="12">
                  <c:v>0.43994800000000001</c:v>
                </c:pt>
                <c:pt idx="13">
                  <c:v>0.56469000000000003</c:v>
                </c:pt>
                <c:pt idx="14">
                  <c:v>0.77400400000000003</c:v>
                </c:pt>
                <c:pt idx="15">
                  <c:v>1.0522</c:v>
                </c:pt>
                <c:pt idx="16">
                  <c:v>1.3995299999999999</c:v>
                </c:pt>
                <c:pt idx="17">
                  <c:v>1.7825</c:v>
                </c:pt>
                <c:pt idx="18">
                  <c:v>3.1488100000000001</c:v>
                </c:pt>
                <c:pt idx="19">
                  <c:v>4.76872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D87-4F84-AE6D-90B40A91FD66}"/>
            </c:ext>
          </c:extLst>
        </c:ser>
        <c:ser>
          <c:idx val="3"/>
          <c:order val="3"/>
          <c:tx>
            <c:v>LN Met 2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27:$E$30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27:$F$30</c:f>
              <c:numCache>
                <c:formatCode>General</c:formatCode>
                <c:ptCount val="4"/>
                <c:pt idx="0">
                  <c:v>0.33692</c:v>
                </c:pt>
                <c:pt idx="1">
                  <c:v>3.2059299999999999</c:v>
                </c:pt>
                <c:pt idx="2">
                  <c:v>4.8679800000000002</c:v>
                </c:pt>
                <c:pt idx="3">
                  <c:v>4.86798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D87-4F84-AE6D-90B40A91FD66}"/>
            </c:ext>
          </c:extLst>
        </c:ser>
        <c:ser>
          <c:idx val="4"/>
          <c:order val="4"/>
          <c:tx>
            <c:strRef>
              <c:f>'Patlak_10-88_cohort-B-S0019'!$A$47</c:f>
              <c:strCache>
                <c:ptCount val="1"/>
                <c:pt idx="0">
                  <c:v>LN Met 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48:$A$67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48:$B$67</c:f>
              <c:numCache>
                <c:formatCode>General</c:formatCode>
                <c:ptCount val="20"/>
                <c:pt idx="0">
                  <c:v>7.3385999999999998E-3</c:v>
                </c:pt>
                <c:pt idx="1">
                  <c:v>7.3226100000000002E-2</c:v>
                </c:pt>
                <c:pt idx="2">
                  <c:v>9.2777700000000005E-2</c:v>
                </c:pt>
                <c:pt idx="3">
                  <c:v>0.125941</c:v>
                </c:pt>
                <c:pt idx="4">
                  <c:v>0.106251</c:v>
                </c:pt>
                <c:pt idx="5">
                  <c:v>0.14397699999999999</c:v>
                </c:pt>
                <c:pt idx="6">
                  <c:v>0.14485200000000001</c:v>
                </c:pt>
                <c:pt idx="7">
                  <c:v>0.17683399999999999</c:v>
                </c:pt>
                <c:pt idx="8">
                  <c:v>0.16781599999999999</c:v>
                </c:pt>
                <c:pt idx="9">
                  <c:v>0.20221800000000001</c:v>
                </c:pt>
                <c:pt idx="10">
                  <c:v>0.23619999999999999</c:v>
                </c:pt>
                <c:pt idx="11">
                  <c:v>0.27221800000000002</c:v>
                </c:pt>
                <c:pt idx="12">
                  <c:v>0.35290700000000003</c:v>
                </c:pt>
                <c:pt idx="13">
                  <c:v>0.502</c:v>
                </c:pt>
                <c:pt idx="14">
                  <c:v>0.68483499999999997</c:v>
                </c:pt>
                <c:pt idx="15">
                  <c:v>0.89043899999999998</c:v>
                </c:pt>
                <c:pt idx="16">
                  <c:v>1.1927099999999999</c:v>
                </c:pt>
                <c:pt idx="17">
                  <c:v>1.51231</c:v>
                </c:pt>
                <c:pt idx="18">
                  <c:v>2.7739199999999999</c:v>
                </c:pt>
                <c:pt idx="19">
                  <c:v>4.09738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D87-4F84-AE6D-90B40A91FD66}"/>
            </c:ext>
          </c:extLst>
        </c:ser>
        <c:ser>
          <c:idx val="5"/>
          <c:order val="5"/>
          <c:tx>
            <c:v>LN Met 3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48:$E$51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48:$F$51</c:f>
              <c:numCache>
                <c:formatCode>General</c:formatCode>
                <c:ptCount val="4"/>
                <c:pt idx="0">
                  <c:v>0.27514300000000003</c:v>
                </c:pt>
                <c:pt idx="1">
                  <c:v>2.8037899999999998</c:v>
                </c:pt>
                <c:pt idx="2">
                  <c:v>4.2686700000000002</c:v>
                </c:pt>
                <c:pt idx="3">
                  <c:v>4.26867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0D87-4F84-AE6D-90B40A91FD66}"/>
            </c:ext>
          </c:extLst>
        </c:ser>
        <c:ser>
          <c:idx val="6"/>
          <c:order val="6"/>
          <c:tx>
            <c:strRef>
              <c:f>'Patlak_10-88_cohort-B-S0019'!$A$68</c:f>
              <c:strCache>
                <c:ptCount val="1"/>
                <c:pt idx="0">
                  <c:v>LN Met 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69:$A$88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69:$B$88</c:f>
              <c:numCache>
                <c:formatCode>General</c:formatCode>
                <c:ptCount val="20"/>
                <c:pt idx="0">
                  <c:v>1.8021700000000001E-3</c:v>
                </c:pt>
                <c:pt idx="1">
                  <c:v>7.87157E-2</c:v>
                </c:pt>
                <c:pt idx="2">
                  <c:v>9.1983599999999999E-2</c:v>
                </c:pt>
                <c:pt idx="3">
                  <c:v>0.104813</c:v>
                </c:pt>
                <c:pt idx="4">
                  <c:v>0.112805</c:v>
                </c:pt>
                <c:pt idx="5">
                  <c:v>0.11587</c:v>
                </c:pt>
                <c:pt idx="6">
                  <c:v>0.12278600000000001</c:v>
                </c:pt>
                <c:pt idx="7">
                  <c:v>0.13993800000000001</c:v>
                </c:pt>
                <c:pt idx="8">
                  <c:v>0.17238700000000001</c:v>
                </c:pt>
                <c:pt idx="9">
                  <c:v>0.190659</c:v>
                </c:pt>
                <c:pt idx="10">
                  <c:v>0.23313999999999999</c:v>
                </c:pt>
                <c:pt idx="11">
                  <c:v>0.28829199999999999</c:v>
                </c:pt>
                <c:pt idx="12">
                  <c:v>0.38489299999999999</c:v>
                </c:pt>
                <c:pt idx="13">
                  <c:v>0.51809300000000003</c:v>
                </c:pt>
                <c:pt idx="14">
                  <c:v>0.72777199999999997</c:v>
                </c:pt>
                <c:pt idx="15">
                  <c:v>0.95354399999999995</c:v>
                </c:pt>
                <c:pt idx="16">
                  <c:v>1.27034</c:v>
                </c:pt>
                <c:pt idx="17">
                  <c:v>1.6345700000000001</c:v>
                </c:pt>
                <c:pt idx="18">
                  <c:v>3.2276899999999999</c:v>
                </c:pt>
                <c:pt idx="19">
                  <c:v>4.91335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0D87-4F84-AE6D-90B40A91FD66}"/>
            </c:ext>
          </c:extLst>
        </c:ser>
        <c:ser>
          <c:idx val="7"/>
          <c:order val="7"/>
          <c:tx>
            <c:v>LN Met 4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69:$E$72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69:$F$72</c:f>
              <c:numCache>
                <c:formatCode>General</c:formatCode>
                <c:ptCount val="4"/>
                <c:pt idx="0">
                  <c:v>0.213365</c:v>
                </c:pt>
                <c:pt idx="1">
                  <c:v>3.2329300000000001</c:v>
                </c:pt>
                <c:pt idx="2">
                  <c:v>4.9821999999999997</c:v>
                </c:pt>
                <c:pt idx="3">
                  <c:v>4.9821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0D87-4F84-AE6D-90B40A91FD66}"/>
            </c:ext>
          </c:extLst>
        </c:ser>
        <c:ser>
          <c:idx val="8"/>
          <c:order val="8"/>
          <c:tx>
            <c:strRef>
              <c:f>'Patlak_10-88_cohort-B-S0019'!$A$89</c:f>
              <c:strCache>
                <c:ptCount val="1"/>
                <c:pt idx="0">
                  <c:v>LN Met 5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90:$A$109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90:$B$109</c:f>
              <c:numCache>
                <c:formatCode>General</c:formatCode>
                <c:ptCount val="20"/>
                <c:pt idx="0" formatCode="0.00E+00">
                  <c:v>2.7694800000000001E-5</c:v>
                </c:pt>
                <c:pt idx="1">
                  <c:v>3.0358099999999999E-2</c:v>
                </c:pt>
                <c:pt idx="2">
                  <c:v>5.6955699999999998E-2</c:v>
                </c:pt>
                <c:pt idx="3">
                  <c:v>4.1985300000000003E-2</c:v>
                </c:pt>
                <c:pt idx="4">
                  <c:v>2.6016899999999999E-2</c:v>
                </c:pt>
                <c:pt idx="5">
                  <c:v>0.11057699999999999</c:v>
                </c:pt>
                <c:pt idx="6">
                  <c:v>5.0916000000000003E-2</c:v>
                </c:pt>
                <c:pt idx="7">
                  <c:v>6.4766900000000002E-2</c:v>
                </c:pt>
                <c:pt idx="8">
                  <c:v>5.9050199999999997E-2</c:v>
                </c:pt>
                <c:pt idx="9">
                  <c:v>0.11963699999999999</c:v>
                </c:pt>
                <c:pt idx="10">
                  <c:v>0.108775</c:v>
                </c:pt>
                <c:pt idx="11">
                  <c:v>0.17293500000000001</c:v>
                </c:pt>
                <c:pt idx="12">
                  <c:v>0.211704</c:v>
                </c:pt>
                <c:pt idx="13">
                  <c:v>0.27925800000000001</c:v>
                </c:pt>
                <c:pt idx="14">
                  <c:v>0.59801400000000005</c:v>
                </c:pt>
                <c:pt idx="15">
                  <c:v>0.79739199999999999</c:v>
                </c:pt>
                <c:pt idx="16">
                  <c:v>1.0418799999999999</c:v>
                </c:pt>
                <c:pt idx="17">
                  <c:v>1.0916600000000001</c:v>
                </c:pt>
                <c:pt idx="18">
                  <c:v>2.9711099999999999</c:v>
                </c:pt>
                <c:pt idx="19">
                  <c:v>3.893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0D87-4F84-AE6D-90B40A91FD66}"/>
            </c:ext>
          </c:extLst>
        </c:ser>
        <c:ser>
          <c:idx val="9"/>
          <c:order val="9"/>
          <c:tx>
            <c:v>LN Met 5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90:$E$93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90:$F$93</c:f>
              <c:numCache>
                <c:formatCode>General</c:formatCode>
                <c:ptCount val="4"/>
                <c:pt idx="0">
                  <c:v>8.9704999999999993E-3</c:v>
                </c:pt>
                <c:pt idx="1">
                  <c:v>2.8887999999999998</c:v>
                </c:pt>
                <c:pt idx="2">
                  <c:v>4.5571200000000003</c:v>
                </c:pt>
                <c:pt idx="3">
                  <c:v>4.55712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0D87-4F84-AE6D-90B40A91FD66}"/>
            </c:ext>
          </c:extLst>
        </c:ser>
        <c:ser>
          <c:idx val="10"/>
          <c:order val="10"/>
          <c:tx>
            <c:strRef>
              <c:f>'Patlak_10-88_cohort-B-S0019'!$A$110</c:f>
              <c:strCache>
                <c:ptCount val="1"/>
                <c:pt idx="0">
                  <c:v>LN Met 6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111:$A$130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111:$B$130</c:f>
              <c:numCache>
                <c:formatCode>General</c:formatCode>
                <c:ptCount val="20"/>
                <c:pt idx="0" formatCode="0.00E+00">
                  <c:v>9.9399600000000003E-5</c:v>
                </c:pt>
                <c:pt idx="1">
                  <c:v>2.7328100000000001E-2</c:v>
                </c:pt>
                <c:pt idx="2">
                  <c:v>8.0758399999999994E-2</c:v>
                </c:pt>
                <c:pt idx="3">
                  <c:v>0.116823</c:v>
                </c:pt>
                <c:pt idx="4">
                  <c:v>5.2570400000000003E-2</c:v>
                </c:pt>
                <c:pt idx="5">
                  <c:v>7.7051800000000004E-2</c:v>
                </c:pt>
                <c:pt idx="6">
                  <c:v>7.0775699999999997E-2</c:v>
                </c:pt>
                <c:pt idx="7">
                  <c:v>0.104509</c:v>
                </c:pt>
                <c:pt idx="8">
                  <c:v>0.119003</c:v>
                </c:pt>
                <c:pt idx="9">
                  <c:v>0.13727</c:v>
                </c:pt>
                <c:pt idx="10">
                  <c:v>0.19598599999999999</c:v>
                </c:pt>
                <c:pt idx="11">
                  <c:v>0.18077299999999999</c:v>
                </c:pt>
                <c:pt idx="12">
                  <c:v>0.233127</c:v>
                </c:pt>
                <c:pt idx="13">
                  <c:v>0.33610699999999999</c:v>
                </c:pt>
                <c:pt idx="14">
                  <c:v>0.55561000000000005</c:v>
                </c:pt>
                <c:pt idx="15">
                  <c:v>0.70379700000000001</c:v>
                </c:pt>
                <c:pt idx="16">
                  <c:v>0.96459300000000003</c:v>
                </c:pt>
                <c:pt idx="17">
                  <c:v>1.1397900000000001</c:v>
                </c:pt>
                <c:pt idx="18">
                  <c:v>2.0398299999999998</c:v>
                </c:pt>
                <c:pt idx="19">
                  <c:v>2.74311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0D87-4F84-AE6D-90B40A91FD66}"/>
            </c:ext>
          </c:extLst>
        </c:ser>
        <c:ser>
          <c:idx val="11"/>
          <c:order val="11"/>
          <c:tx>
            <c:v>LN Met 6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111:$E$114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111:$F$114</c:f>
              <c:numCache>
                <c:formatCode>General</c:formatCode>
                <c:ptCount val="4"/>
                <c:pt idx="0">
                  <c:v>0.24141099999999999</c:v>
                </c:pt>
                <c:pt idx="1">
                  <c:v>2.07891</c:v>
                </c:pt>
                <c:pt idx="2">
                  <c:v>3.1434000000000002</c:v>
                </c:pt>
                <c:pt idx="3">
                  <c:v>3.1434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0D87-4F84-AE6D-90B40A91FD66}"/>
            </c:ext>
          </c:extLst>
        </c:ser>
        <c:ser>
          <c:idx val="12"/>
          <c:order val="12"/>
          <c:tx>
            <c:strRef>
              <c:f>'Patlak_10-88_cohort-B-S0019'!$A$131</c:f>
              <c:strCache>
                <c:ptCount val="1"/>
                <c:pt idx="0">
                  <c:v>LN Met 7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132:$A$151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132:$B$151</c:f>
              <c:numCache>
                <c:formatCode>General</c:formatCode>
                <c:ptCount val="20"/>
                <c:pt idx="0">
                  <c:v>3.7140300000000001E-3</c:v>
                </c:pt>
                <c:pt idx="1">
                  <c:v>7.3081400000000005E-2</c:v>
                </c:pt>
                <c:pt idx="2">
                  <c:v>8.5641800000000004E-2</c:v>
                </c:pt>
                <c:pt idx="3">
                  <c:v>9.2957399999999996E-2</c:v>
                </c:pt>
                <c:pt idx="4">
                  <c:v>9.7762000000000002E-2</c:v>
                </c:pt>
                <c:pt idx="5">
                  <c:v>0.121145</c:v>
                </c:pt>
                <c:pt idx="6">
                  <c:v>0.113897</c:v>
                </c:pt>
                <c:pt idx="7">
                  <c:v>0.12765199999999999</c:v>
                </c:pt>
                <c:pt idx="8">
                  <c:v>0.13380300000000001</c:v>
                </c:pt>
                <c:pt idx="9">
                  <c:v>0.15176000000000001</c:v>
                </c:pt>
                <c:pt idx="10">
                  <c:v>0.18782499999999999</c:v>
                </c:pt>
                <c:pt idx="11">
                  <c:v>0.25999699999999998</c:v>
                </c:pt>
                <c:pt idx="12">
                  <c:v>0.34165600000000002</c:v>
                </c:pt>
                <c:pt idx="13">
                  <c:v>0.47358299999999998</c:v>
                </c:pt>
                <c:pt idx="14">
                  <c:v>0.66926099999999999</c:v>
                </c:pt>
                <c:pt idx="15">
                  <c:v>0.84044200000000002</c:v>
                </c:pt>
                <c:pt idx="16">
                  <c:v>1.10277</c:v>
                </c:pt>
                <c:pt idx="17">
                  <c:v>1.37086</c:v>
                </c:pt>
                <c:pt idx="18">
                  <c:v>2.66899</c:v>
                </c:pt>
                <c:pt idx="19">
                  <c:v>4.21501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0D87-4F84-AE6D-90B40A91FD66}"/>
            </c:ext>
          </c:extLst>
        </c:ser>
        <c:ser>
          <c:idx val="13"/>
          <c:order val="13"/>
          <c:tx>
            <c:v>LN Met 7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132:$E$135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132:$F$135</c:f>
              <c:numCache>
                <c:formatCode>General</c:formatCode>
                <c:ptCount val="4"/>
                <c:pt idx="0">
                  <c:v>0.24226600000000001</c:v>
                </c:pt>
                <c:pt idx="1">
                  <c:v>2.6711299999999998</c:v>
                </c:pt>
                <c:pt idx="2">
                  <c:v>4.0781999999999998</c:v>
                </c:pt>
                <c:pt idx="3">
                  <c:v>4.0781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0D87-4F84-AE6D-90B40A91FD66}"/>
            </c:ext>
          </c:extLst>
        </c:ser>
        <c:ser>
          <c:idx val="14"/>
          <c:order val="14"/>
          <c:tx>
            <c:strRef>
              <c:f>'Patlak_10-88_cohort-B-S0019'!$A$152</c:f>
              <c:strCache>
                <c:ptCount val="1"/>
                <c:pt idx="0">
                  <c:v>LN Met 8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153:$A$172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153:$B$172</c:f>
              <c:numCache>
                <c:formatCode>General</c:formatCode>
                <c:ptCount val="20"/>
                <c:pt idx="0">
                  <c:v>2.7806899999999998E-4</c:v>
                </c:pt>
                <c:pt idx="1">
                  <c:v>3.6969700000000001E-2</c:v>
                </c:pt>
                <c:pt idx="2">
                  <c:v>8.8306399999999993E-2</c:v>
                </c:pt>
                <c:pt idx="3">
                  <c:v>0.10605299999999999</c:v>
                </c:pt>
                <c:pt idx="4">
                  <c:v>0.133992</c:v>
                </c:pt>
                <c:pt idx="5">
                  <c:v>0.16728899999999999</c:v>
                </c:pt>
                <c:pt idx="6">
                  <c:v>0.14744699999999999</c:v>
                </c:pt>
                <c:pt idx="7">
                  <c:v>0.14078599999999999</c:v>
                </c:pt>
                <c:pt idx="8">
                  <c:v>0.15229899999999999</c:v>
                </c:pt>
                <c:pt idx="9">
                  <c:v>0.172404</c:v>
                </c:pt>
                <c:pt idx="10">
                  <c:v>0.19165399999999999</c:v>
                </c:pt>
                <c:pt idx="11">
                  <c:v>0.25997300000000001</c:v>
                </c:pt>
                <c:pt idx="12">
                  <c:v>0.35739599999999999</c:v>
                </c:pt>
                <c:pt idx="13">
                  <c:v>0.46904899999999999</c:v>
                </c:pt>
                <c:pt idx="14">
                  <c:v>0.61468999999999996</c:v>
                </c:pt>
                <c:pt idx="15">
                  <c:v>0.901092</c:v>
                </c:pt>
                <c:pt idx="16">
                  <c:v>1.22817</c:v>
                </c:pt>
                <c:pt idx="17">
                  <c:v>1.54217</c:v>
                </c:pt>
                <c:pt idx="18">
                  <c:v>2.5163799999999998</c:v>
                </c:pt>
                <c:pt idx="19">
                  <c:v>4.12077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0D87-4F84-AE6D-90B40A91FD66}"/>
            </c:ext>
          </c:extLst>
        </c:ser>
        <c:ser>
          <c:idx val="15"/>
          <c:order val="15"/>
          <c:tx>
            <c:v>LN Met 8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153:$E$156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153:$F$156</c:f>
              <c:numCache>
                <c:formatCode>General</c:formatCode>
                <c:ptCount val="4"/>
                <c:pt idx="0">
                  <c:v>0.32583000000000001</c:v>
                </c:pt>
                <c:pt idx="1">
                  <c:v>2.60236</c:v>
                </c:pt>
                <c:pt idx="2">
                  <c:v>3.9211900000000002</c:v>
                </c:pt>
                <c:pt idx="3">
                  <c:v>3.92119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0D87-4F84-AE6D-90B40A91FD66}"/>
            </c:ext>
          </c:extLst>
        </c:ser>
        <c:ser>
          <c:idx val="16"/>
          <c:order val="16"/>
          <c:tx>
            <c:strRef>
              <c:f>'Patlak_10-88_cohort-B-S0019'!$A$173</c:f>
              <c:strCache>
                <c:ptCount val="1"/>
                <c:pt idx="0">
                  <c:v>Bone (Reference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B-S0019'!$A$174:$A$193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174:$B$193</c:f>
              <c:numCache>
                <c:formatCode>General</c:formatCode>
                <c:ptCount val="20"/>
                <c:pt idx="0">
                  <c:v>1.1315E-4</c:v>
                </c:pt>
                <c:pt idx="1">
                  <c:v>1.61397E-2</c:v>
                </c:pt>
                <c:pt idx="2">
                  <c:v>4.2570299999999998E-2</c:v>
                </c:pt>
                <c:pt idx="3">
                  <c:v>5.7715200000000001E-2</c:v>
                </c:pt>
                <c:pt idx="4">
                  <c:v>6.4063099999999998E-2</c:v>
                </c:pt>
                <c:pt idx="5">
                  <c:v>6.1108999999999997E-2</c:v>
                </c:pt>
                <c:pt idx="6">
                  <c:v>6.14537E-2</c:v>
                </c:pt>
                <c:pt idx="7">
                  <c:v>7.0071400000000006E-2</c:v>
                </c:pt>
                <c:pt idx="8">
                  <c:v>6.7111400000000002E-2</c:v>
                </c:pt>
                <c:pt idx="9">
                  <c:v>7.1154599999999998E-2</c:v>
                </c:pt>
                <c:pt idx="10">
                  <c:v>7.1579599999999993E-2</c:v>
                </c:pt>
                <c:pt idx="11">
                  <c:v>6.8103800000000006E-2</c:v>
                </c:pt>
                <c:pt idx="12">
                  <c:v>7.1741299999999994E-2</c:v>
                </c:pt>
                <c:pt idx="13">
                  <c:v>7.1464299999999994E-2</c:v>
                </c:pt>
                <c:pt idx="14">
                  <c:v>7.7216000000000007E-2</c:v>
                </c:pt>
                <c:pt idx="15">
                  <c:v>8.0135499999999998E-2</c:v>
                </c:pt>
                <c:pt idx="16">
                  <c:v>9.4012100000000001E-2</c:v>
                </c:pt>
                <c:pt idx="17">
                  <c:v>0.10317999999999999</c:v>
                </c:pt>
                <c:pt idx="18">
                  <c:v>0.18801399999999999</c:v>
                </c:pt>
                <c:pt idx="19">
                  <c:v>0.29192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0D87-4F84-AE6D-90B40A91FD66}"/>
            </c:ext>
          </c:extLst>
        </c:ser>
        <c:ser>
          <c:idx val="17"/>
          <c:order val="17"/>
          <c:tx>
            <c:v>Bon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174:$E$177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174:$F$177</c:f>
              <c:numCache>
                <c:formatCode>General</c:formatCode>
                <c:ptCount val="4"/>
                <c:pt idx="0">
                  <c:v>5.0814400000000003E-2</c:v>
                </c:pt>
                <c:pt idx="1">
                  <c:v>0.18318499999999999</c:v>
                </c:pt>
                <c:pt idx="2">
                  <c:v>0.25986900000000002</c:v>
                </c:pt>
                <c:pt idx="3">
                  <c:v>0.259869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0D87-4F84-AE6D-90B40A91FD66}"/>
            </c:ext>
          </c:extLst>
        </c:ser>
        <c:ser>
          <c:idx val="18"/>
          <c:order val="18"/>
          <c:tx>
            <c:strRef>
              <c:f>'Patlak_10-88_cohort-B-S0019'!$A$194</c:f>
              <c:strCache>
                <c:ptCount val="1"/>
                <c:pt idx="0">
                  <c:v>Muscle (Reference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'Patlak_10-88_cohort-B-S0019'!$A$195:$A$214</c:f>
              <c:numCache>
                <c:formatCode>General</c:formatCode>
                <c:ptCount val="20"/>
                <c:pt idx="0">
                  <c:v>6.2263199999999996E-3</c:v>
                </c:pt>
                <c:pt idx="1">
                  <c:v>0.28766199999999997</c:v>
                </c:pt>
                <c:pt idx="2">
                  <c:v>0.73960800000000004</c:v>
                </c:pt>
                <c:pt idx="3">
                  <c:v>1.24413</c:v>
                </c:pt>
                <c:pt idx="4">
                  <c:v>1.6915800000000001</c:v>
                </c:pt>
                <c:pt idx="5">
                  <c:v>2.0964399999999999</c:v>
                </c:pt>
                <c:pt idx="6">
                  <c:v>2.48861</c:v>
                </c:pt>
                <c:pt idx="7">
                  <c:v>2.8820700000000001</c:v>
                </c:pt>
                <c:pt idx="8">
                  <c:v>3.2815099999999999</c:v>
                </c:pt>
                <c:pt idx="9">
                  <c:v>4.1020099999999999</c:v>
                </c:pt>
                <c:pt idx="10">
                  <c:v>5.3925599999999996</c:v>
                </c:pt>
                <c:pt idx="11">
                  <c:v>7.81135</c:v>
                </c:pt>
                <c:pt idx="12">
                  <c:v>11.638199999999999</c:v>
                </c:pt>
                <c:pt idx="13">
                  <c:v>18.053999999999998</c:v>
                </c:pt>
                <c:pt idx="14">
                  <c:v>27.7681</c:v>
                </c:pt>
                <c:pt idx="15">
                  <c:v>38.311900000000001</c:v>
                </c:pt>
                <c:pt idx="16">
                  <c:v>54.578000000000003</c:v>
                </c:pt>
                <c:pt idx="17">
                  <c:v>76.922700000000006</c:v>
                </c:pt>
                <c:pt idx="18">
                  <c:v>161.47800000000001</c:v>
                </c:pt>
                <c:pt idx="19">
                  <c:v>255.02500000000001</c:v>
                </c:pt>
              </c:numCache>
            </c:numRef>
          </c:xVal>
          <c:yVal>
            <c:numRef>
              <c:f>'Patlak_10-88_cohort-B-S0019'!$B$195:$B$214</c:f>
              <c:numCache>
                <c:formatCode>General</c:formatCode>
                <c:ptCount val="20"/>
                <c:pt idx="0">
                  <c:v>1.3306400000000001E-4</c:v>
                </c:pt>
                <c:pt idx="1">
                  <c:v>7.0962000000000004E-3</c:v>
                </c:pt>
                <c:pt idx="2">
                  <c:v>2.3686599999999999E-2</c:v>
                </c:pt>
                <c:pt idx="3">
                  <c:v>2.9269799999999999E-2</c:v>
                </c:pt>
                <c:pt idx="4">
                  <c:v>3.2123100000000002E-2</c:v>
                </c:pt>
                <c:pt idx="5">
                  <c:v>3.2644899999999998E-2</c:v>
                </c:pt>
                <c:pt idx="6">
                  <c:v>3.2741100000000002E-2</c:v>
                </c:pt>
                <c:pt idx="7">
                  <c:v>3.5261899999999999E-2</c:v>
                </c:pt>
                <c:pt idx="8">
                  <c:v>3.8646300000000001E-2</c:v>
                </c:pt>
                <c:pt idx="9">
                  <c:v>3.7221999999999998E-2</c:v>
                </c:pt>
                <c:pt idx="10">
                  <c:v>4.0661000000000003E-2</c:v>
                </c:pt>
                <c:pt idx="11">
                  <c:v>4.4761500000000003E-2</c:v>
                </c:pt>
                <c:pt idx="12">
                  <c:v>4.9362900000000001E-2</c:v>
                </c:pt>
                <c:pt idx="13">
                  <c:v>5.48878E-2</c:v>
                </c:pt>
                <c:pt idx="14">
                  <c:v>6.1453199999999999E-2</c:v>
                </c:pt>
                <c:pt idx="15">
                  <c:v>6.6264400000000001E-2</c:v>
                </c:pt>
                <c:pt idx="16">
                  <c:v>6.7910499999999999E-2</c:v>
                </c:pt>
                <c:pt idx="17">
                  <c:v>7.4571799999999994E-2</c:v>
                </c:pt>
                <c:pt idx="18">
                  <c:v>0.12216200000000001</c:v>
                </c:pt>
                <c:pt idx="19">
                  <c:v>0.15876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0D87-4F84-AE6D-90B40A91FD66}"/>
            </c:ext>
          </c:extLst>
        </c:ser>
        <c:ser>
          <c:idx val="19"/>
          <c:order val="19"/>
          <c:tx>
            <c:v>Muscl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B-S0019'!$E$195:$E$198</c:f>
              <c:numCache>
                <c:formatCode>General</c:formatCode>
                <c:ptCount val="4"/>
                <c:pt idx="0">
                  <c:v>0</c:v>
                </c:pt>
                <c:pt idx="1">
                  <c:v>161.47800000000001</c:v>
                </c:pt>
                <c:pt idx="2">
                  <c:v>255.02500000000001</c:v>
                </c:pt>
                <c:pt idx="3">
                  <c:v>255.02500000000001</c:v>
                </c:pt>
              </c:numCache>
            </c:numRef>
          </c:xVal>
          <c:yVal>
            <c:numRef>
              <c:f>'Patlak_10-88_cohort-B-S0019'!$F$195:$F$198</c:f>
              <c:numCache>
                <c:formatCode>General</c:formatCode>
                <c:ptCount val="4"/>
                <c:pt idx="0">
                  <c:v>4.5941999999999997E-2</c:v>
                </c:pt>
                <c:pt idx="1">
                  <c:v>0.119419</c:v>
                </c:pt>
                <c:pt idx="2">
                  <c:v>0.16198599999999999</c:v>
                </c:pt>
                <c:pt idx="3">
                  <c:v>0.16198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0D87-4F84-AE6D-90B40A91FD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5145064"/>
        <c:axId val="305140360"/>
      </c:scatterChart>
      <c:valAx>
        <c:axId val="305145064"/>
        <c:scaling>
          <c:orientation val="minMax"/>
          <c:max val="260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Input Integral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305140360"/>
        <c:crosses val="autoZero"/>
        <c:crossBetween val="midCat"/>
        <c:majorUnit val="50"/>
      </c:valAx>
      <c:valAx>
        <c:axId val="305140360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Tissue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305145064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tr"/>
      <c:legendEntry>
        <c:idx val="0"/>
        <c:delete val="1"/>
      </c:legendEntry>
      <c:legendEntry>
        <c:idx val="3"/>
        <c:delete val="1"/>
      </c:legendEntry>
      <c:legendEntry>
        <c:idx val="5"/>
        <c:delete val="1"/>
      </c:legendEntry>
      <c:legendEntry>
        <c:idx val="7"/>
        <c:delete val="1"/>
      </c:legendEntry>
      <c:legendEntry>
        <c:idx val="9"/>
        <c:delete val="1"/>
      </c:legendEntry>
      <c:legendEntry>
        <c:idx val="11"/>
        <c:delete val="1"/>
      </c:legendEntry>
      <c:legendEntry>
        <c:idx val="13"/>
        <c:delete val="1"/>
      </c:legendEntry>
      <c:legendEntry>
        <c:idx val="15"/>
        <c:delete val="1"/>
      </c:legendEntry>
      <c:legendEntry>
        <c:idx val="17"/>
        <c:delete val="1"/>
      </c:legendEntry>
      <c:legendEntry>
        <c:idx val="19"/>
        <c:delete val="1"/>
      </c:legendEntry>
      <c:layout>
        <c:manualLayout>
          <c:xMode val="edge"/>
          <c:yMode val="edge"/>
          <c:x val="0.18329154847667367"/>
          <c:y val="2.1590573270442649E-2"/>
          <c:w val="0.56458591014179627"/>
          <c:h val="0.26435134045572367"/>
        </c:manualLayout>
      </c:layout>
      <c:overlay val="1"/>
      <c:spPr>
        <a:noFill/>
        <a:ln>
          <a:solidFill>
            <a:schemeClr val="bg1">
              <a:lumMod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>
                <a:solidFill>
                  <a:schemeClr val="tx1"/>
                </a:solidFill>
              </a:rPr>
              <a:t>Cohort A</a:t>
            </a:r>
          </a:p>
        </c:rich>
      </c:tx>
      <c:layout>
        <c:manualLayout>
          <c:xMode val="edge"/>
          <c:yMode val="edge"/>
          <c:x val="2.4746745927141003E-2"/>
          <c:y val="2.00650711858715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title>
    <c:autoTitleDeleted val="0"/>
    <c:plotArea>
      <c:layout>
        <c:manualLayout>
          <c:layoutTarget val="inner"/>
          <c:xMode val="edge"/>
          <c:yMode val="edge"/>
          <c:x val="0.13095530298328989"/>
          <c:y val="0.19031307584886514"/>
          <c:w val="0.78492391494627411"/>
          <c:h val="0.68395653544531565"/>
        </c:manualLayout>
      </c:layout>
      <c:scatterChart>
        <c:scatterStyle val="lineMarker"/>
        <c:varyColors val="0"/>
        <c:ser>
          <c:idx val="1"/>
          <c:order val="0"/>
          <c:tx>
            <c:strRef>
              <c:f>'Patlak_10-88_cohort-A-S0021'!$A$47</c:f>
              <c:strCache>
                <c:ptCount val="1"/>
                <c:pt idx="0">
                  <c:v>Prostate Lesion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9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A-S0021'!$A$48:$A$67</c:f>
              <c:numCache>
                <c:formatCode>General</c:formatCode>
                <c:ptCount val="20"/>
                <c:pt idx="0">
                  <c:v>0</c:v>
                </c:pt>
                <c:pt idx="1">
                  <c:v>0.14985299999999999</c:v>
                </c:pt>
                <c:pt idx="2">
                  <c:v>0.389955</c:v>
                </c:pt>
                <c:pt idx="3">
                  <c:v>0.69252899999999995</c:v>
                </c:pt>
                <c:pt idx="4">
                  <c:v>1.0505500000000001</c:v>
                </c:pt>
                <c:pt idx="5">
                  <c:v>1.45017</c:v>
                </c:pt>
                <c:pt idx="6">
                  <c:v>1.87564</c:v>
                </c:pt>
                <c:pt idx="7">
                  <c:v>2.3138700000000001</c:v>
                </c:pt>
                <c:pt idx="8">
                  <c:v>2.75678</c:v>
                </c:pt>
                <c:pt idx="9">
                  <c:v>3.6397599999999999</c:v>
                </c:pt>
                <c:pt idx="10">
                  <c:v>4.9894400000000001</c:v>
                </c:pt>
                <c:pt idx="11">
                  <c:v>7.4614599999999998</c:v>
                </c:pt>
                <c:pt idx="12">
                  <c:v>11.3565</c:v>
                </c:pt>
                <c:pt idx="13">
                  <c:v>17.776700000000002</c:v>
                </c:pt>
                <c:pt idx="14">
                  <c:v>27.106300000000001</c:v>
                </c:pt>
                <c:pt idx="15">
                  <c:v>36.593299999999999</c:v>
                </c:pt>
                <c:pt idx="16">
                  <c:v>50.168500000000002</c:v>
                </c:pt>
                <c:pt idx="17">
                  <c:v>67.582899999999995</c:v>
                </c:pt>
                <c:pt idx="18">
                  <c:v>130.65700000000001</c:v>
                </c:pt>
                <c:pt idx="19">
                  <c:v>195.55199999999999</c:v>
                </c:pt>
              </c:numCache>
            </c:numRef>
          </c:xVal>
          <c:yVal>
            <c:numRef>
              <c:f>'Patlak_10-88_cohort-A-S0021'!$B$48:$B$67</c:f>
              <c:numCache>
                <c:formatCode>General</c:formatCode>
                <c:ptCount val="20"/>
                <c:pt idx="0">
                  <c:v>3.0856099999999999E-3</c:v>
                </c:pt>
                <c:pt idx="1">
                  <c:v>3.2154900000000001E-3</c:v>
                </c:pt>
                <c:pt idx="2">
                  <c:v>4.3610700000000002E-2</c:v>
                </c:pt>
                <c:pt idx="3">
                  <c:v>6.2027199999999998E-2</c:v>
                </c:pt>
                <c:pt idx="4">
                  <c:v>9.0158699999999994E-2</c:v>
                </c:pt>
                <c:pt idx="5">
                  <c:v>9.3448600000000007E-2</c:v>
                </c:pt>
                <c:pt idx="6">
                  <c:v>0.10517700000000001</c:v>
                </c:pt>
                <c:pt idx="7">
                  <c:v>0.113749</c:v>
                </c:pt>
                <c:pt idx="8">
                  <c:v>0.117283</c:v>
                </c:pt>
                <c:pt idx="9">
                  <c:v>0.14912300000000001</c:v>
                </c:pt>
                <c:pt idx="10">
                  <c:v>0.17219899999999999</c:v>
                </c:pt>
                <c:pt idx="11">
                  <c:v>0.20400099999999999</c:v>
                </c:pt>
                <c:pt idx="12">
                  <c:v>0.26132499999999997</c:v>
                </c:pt>
                <c:pt idx="13">
                  <c:v>0.30427500000000002</c:v>
                </c:pt>
                <c:pt idx="14">
                  <c:v>0.36232199999999998</c:v>
                </c:pt>
                <c:pt idx="15">
                  <c:v>0.41672399999999998</c:v>
                </c:pt>
                <c:pt idx="16">
                  <c:v>0.49204300000000001</c:v>
                </c:pt>
                <c:pt idx="17">
                  <c:v>0.58853999999999995</c:v>
                </c:pt>
                <c:pt idx="18">
                  <c:v>0.86523399999999995</c:v>
                </c:pt>
                <c:pt idx="19">
                  <c:v>1.10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0BC-4DBB-8326-7FB223DFECDC}"/>
            </c:ext>
          </c:extLst>
        </c:ser>
        <c:ser>
          <c:idx val="3"/>
          <c:order val="1"/>
          <c:tx>
            <c:strRef>
              <c:f>'Patlak_10-88_cohort-A-S0021'!$A$5</c:f>
              <c:strCache>
                <c:ptCount val="1"/>
                <c:pt idx="0">
                  <c:v>Bone (Reference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A-S0021'!$A$6:$A$25</c:f>
              <c:numCache>
                <c:formatCode>General</c:formatCode>
                <c:ptCount val="20"/>
                <c:pt idx="0">
                  <c:v>0</c:v>
                </c:pt>
                <c:pt idx="1">
                  <c:v>0.14985299999999999</c:v>
                </c:pt>
                <c:pt idx="2">
                  <c:v>0.389955</c:v>
                </c:pt>
                <c:pt idx="3">
                  <c:v>0.69252899999999995</c:v>
                </c:pt>
                <c:pt idx="4">
                  <c:v>1.0505500000000001</c:v>
                </c:pt>
                <c:pt idx="5">
                  <c:v>1.45017</c:v>
                </c:pt>
                <c:pt idx="6">
                  <c:v>1.87564</c:v>
                </c:pt>
                <c:pt idx="7">
                  <c:v>2.3138700000000001</c:v>
                </c:pt>
                <c:pt idx="8">
                  <c:v>2.75678</c:v>
                </c:pt>
                <c:pt idx="9">
                  <c:v>3.6397599999999999</c:v>
                </c:pt>
                <c:pt idx="10">
                  <c:v>4.9894400000000001</c:v>
                </c:pt>
                <c:pt idx="11">
                  <c:v>7.4614599999999998</c:v>
                </c:pt>
                <c:pt idx="12">
                  <c:v>11.3565</c:v>
                </c:pt>
                <c:pt idx="13">
                  <c:v>17.776700000000002</c:v>
                </c:pt>
                <c:pt idx="14">
                  <c:v>27.106300000000001</c:v>
                </c:pt>
                <c:pt idx="15">
                  <c:v>36.593299999999999</c:v>
                </c:pt>
                <c:pt idx="16">
                  <c:v>50.168500000000002</c:v>
                </c:pt>
                <c:pt idx="17">
                  <c:v>67.582899999999995</c:v>
                </c:pt>
                <c:pt idx="18">
                  <c:v>130.65700000000001</c:v>
                </c:pt>
                <c:pt idx="19">
                  <c:v>195.55199999999999</c:v>
                </c:pt>
              </c:numCache>
            </c:numRef>
          </c:xVal>
          <c:yVal>
            <c:numRef>
              <c:f>'Patlak_10-88_cohort-A-S0021'!$B$6:$B$25</c:f>
              <c:numCache>
                <c:formatCode>General</c:formatCode>
                <c:ptCount val="20"/>
                <c:pt idx="0">
                  <c:v>0</c:v>
                </c:pt>
                <c:pt idx="1">
                  <c:v>4.2236900000000004E-3</c:v>
                </c:pt>
                <c:pt idx="2">
                  <c:v>2.3435000000000001E-2</c:v>
                </c:pt>
                <c:pt idx="3">
                  <c:v>2.8209999999999999E-2</c:v>
                </c:pt>
                <c:pt idx="4">
                  <c:v>3.92705E-2</c:v>
                </c:pt>
                <c:pt idx="5">
                  <c:v>3.7833100000000001E-2</c:v>
                </c:pt>
                <c:pt idx="6">
                  <c:v>5.7319099999999998E-2</c:v>
                </c:pt>
                <c:pt idx="7">
                  <c:v>6.3858300000000007E-2</c:v>
                </c:pt>
                <c:pt idx="8">
                  <c:v>6.3192999999999999E-2</c:v>
                </c:pt>
                <c:pt idx="9">
                  <c:v>6.6897200000000004E-2</c:v>
                </c:pt>
                <c:pt idx="10">
                  <c:v>7.4229000000000003E-2</c:v>
                </c:pt>
                <c:pt idx="11">
                  <c:v>7.9926499999999998E-2</c:v>
                </c:pt>
                <c:pt idx="12">
                  <c:v>8.2055799999999998E-2</c:v>
                </c:pt>
                <c:pt idx="13">
                  <c:v>9.6192600000000003E-2</c:v>
                </c:pt>
                <c:pt idx="14">
                  <c:v>0.100079</c:v>
                </c:pt>
                <c:pt idx="15">
                  <c:v>0.1028</c:v>
                </c:pt>
                <c:pt idx="16">
                  <c:v>0.11550000000000001</c:v>
                </c:pt>
                <c:pt idx="17">
                  <c:v>0.123985</c:v>
                </c:pt>
                <c:pt idx="18">
                  <c:v>0.17053499999999999</c:v>
                </c:pt>
                <c:pt idx="19">
                  <c:v>0.173276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0BC-4DBB-8326-7FB223DFECDC}"/>
            </c:ext>
          </c:extLst>
        </c:ser>
        <c:ser>
          <c:idx val="0"/>
          <c:order val="2"/>
          <c:tx>
            <c:strRef>
              <c:f>'Patlak_10-88_cohort-A-S0021'!$A$26</c:f>
              <c:strCache>
                <c:ptCount val="1"/>
                <c:pt idx="0">
                  <c:v>Muscle (Reference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'Patlak_10-88_cohort-A-S0021'!$A$27:$A$46</c:f>
              <c:numCache>
                <c:formatCode>General</c:formatCode>
                <c:ptCount val="20"/>
                <c:pt idx="0">
                  <c:v>0</c:v>
                </c:pt>
                <c:pt idx="1">
                  <c:v>0.14985299999999999</c:v>
                </c:pt>
                <c:pt idx="2">
                  <c:v>0.389955</c:v>
                </c:pt>
                <c:pt idx="3">
                  <c:v>0.69252899999999995</c:v>
                </c:pt>
                <c:pt idx="4">
                  <c:v>1.0505500000000001</c:v>
                </c:pt>
                <c:pt idx="5">
                  <c:v>1.45017</c:v>
                </c:pt>
                <c:pt idx="6">
                  <c:v>1.87564</c:v>
                </c:pt>
                <c:pt idx="7">
                  <c:v>2.3138700000000001</c:v>
                </c:pt>
                <c:pt idx="8">
                  <c:v>2.75678</c:v>
                </c:pt>
                <c:pt idx="9">
                  <c:v>3.6397599999999999</c:v>
                </c:pt>
                <c:pt idx="10">
                  <c:v>4.9894400000000001</c:v>
                </c:pt>
                <c:pt idx="11">
                  <c:v>7.4614599999999998</c:v>
                </c:pt>
                <c:pt idx="12">
                  <c:v>11.3565</c:v>
                </c:pt>
                <c:pt idx="13">
                  <c:v>17.776700000000002</c:v>
                </c:pt>
                <c:pt idx="14">
                  <c:v>27.106300000000001</c:v>
                </c:pt>
                <c:pt idx="15">
                  <c:v>36.593299999999999</c:v>
                </c:pt>
                <c:pt idx="16">
                  <c:v>50.168500000000002</c:v>
                </c:pt>
                <c:pt idx="17">
                  <c:v>67.582899999999995</c:v>
                </c:pt>
                <c:pt idx="18">
                  <c:v>130.65700000000001</c:v>
                </c:pt>
                <c:pt idx="19">
                  <c:v>195.55199999999999</c:v>
                </c:pt>
              </c:numCache>
            </c:numRef>
          </c:xVal>
          <c:yVal>
            <c:numRef>
              <c:f>'Patlak_10-88_cohort-A-S0021'!$B$27:$B$46</c:f>
              <c:numCache>
                <c:formatCode>General</c:formatCode>
                <c:ptCount val="20"/>
                <c:pt idx="0">
                  <c:v>2.22572E-3</c:v>
                </c:pt>
                <c:pt idx="1">
                  <c:v>6.7073300000000001E-3</c:v>
                </c:pt>
                <c:pt idx="2">
                  <c:v>2.56733E-2</c:v>
                </c:pt>
                <c:pt idx="3">
                  <c:v>3.4999500000000003E-2</c:v>
                </c:pt>
                <c:pt idx="4">
                  <c:v>3.1605500000000002E-2</c:v>
                </c:pt>
                <c:pt idx="5">
                  <c:v>3.2613099999999999E-2</c:v>
                </c:pt>
                <c:pt idx="6">
                  <c:v>3.8730899999999999E-2</c:v>
                </c:pt>
                <c:pt idx="7">
                  <c:v>4.0048199999999999E-2</c:v>
                </c:pt>
                <c:pt idx="8">
                  <c:v>4.0678600000000002E-2</c:v>
                </c:pt>
                <c:pt idx="9">
                  <c:v>4.3539000000000001E-2</c:v>
                </c:pt>
                <c:pt idx="10">
                  <c:v>4.9214300000000002E-2</c:v>
                </c:pt>
                <c:pt idx="11">
                  <c:v>5.7734500000000001E-2</c:v>
                </c:pt>
                <c:pt idx="12">
                  <c:v>6.6098900000000002E-2</c:v>
                </c:pt>
                <c:pt idx="13">
                  <c:v>7.6049599999999995E-2</c:v>
                </c:pt>
                <c:pt idx="14">
                  <c:v>9.3380400000000002E-2</c:v>
                </c:pt>
                <c:pt idx="15">
                  <c:v>0.100185</c:v>
                </c:pt>
                <c:pt idx="16">
                  <c:v>0.10573200000000001</c:v>
                </c:pt>
                <c:pt idx="17">
                  <c:v>0.11128</c:v>
                </c:pt>
                <c:pt idx="18">
                  <c:v>0.121931</c:v>
                </c:pt>
                <c:pt idx="19">
                  <c:v>0.144824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0BC-4DBB-8326-7FB223DFECDC}"/>
            </c:ext>
          </c:extLst>
        </c:ser>
        <c:ser>
          <c:idx val="2"/>
          <c:order val="3"/>
          <c:tx>
            <c:v>Bon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A-S0021'!$E$6:$E$9</c:f>
              <c:numCache>
                <c:formatCode>General</c:formatCode>
                <c:ptCount val="4"/>
                <c:pt idx="0">
                  <c:v>0</c:v>
                </c:pt>
                <c:pt idx="1">
                  <c:v>130.65700000000001</c:v>
                </c:pt>
                <c:pt idx="2">
                  <c:v>195.55199999999999</c:v>
                </c:pt>
                <c:pt idx="3">
                  <c:v>195.55199999999999</c:v>
                </c:pt>
              </c:numCache>
            </c:numRef>
          </c:xVal>
          <c:yVal>
            <c:numRef>
              <c:f>'Patlak_10-88_cohort-A-S0021'!$F$6:$F$9</c:f>
              <c:numCache>
                <c:formatCode>General</c:formatCode>
                <c:ptCount val="4"/>
                <c:pt idx="0">
                  <c:v>8.1213599999999997E-2</c:v>
                </c:pt>
                <c:pt idx="1">
                  <c:v>0.16906499999999999</c:v>
                </c:pt>
                <c:pt idx="2">
                  <c:v>0.2127</c:v>
                </c:pt>
                <c:pt idx="3">
                  <c:v>0.21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0BC-4DBB-8326-7FB223DFECDC}"/>
            </c:ext>
          </c:extLst>
        </c:ser>
        <c:ser>
          <c:idx val="4"/>
          <c:order val="4"/>
          <c:tx>
            <c:v>Muscl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A-S0021'!$E$27:$E$30</c:f>
              <c:numCache>
                <c:formatCode>General</c:formatCode>
                <c:ptCount val="4"/>
                <c:pt idx="0">
                  <c:v>0</c:v>
                </c:pt>
                <c:pt idx="1">
                  <c:v>130.65700000000001</c:v>
                </c:pt>
                <c:pt idx="2">
                  <c:v>195.55199999999999</c:v>
                </c:pt>
                <c:pt idx="3">
                  <c:v>195.55199999999999</c:v>
                </c:pt>
              </c:numCache>
            </c:numRef>
          </c:xVal>
          <c:yVal>
            <c:numRef>
              <c:f>'Patlak_10-88_cohort-A-S0021'!$F$27:$F$30</c:f>
              <c:numCache>
                <c:formatCode>General</c:formatCode>
                <c:ptCount val="4"/>
                <c:pt idx="0">
                  <c:v>8.2813399999999995E-2</c:v>
                </c:pt>
                <c:pt idx="1">
                  <c:v>0.12704499999999999</c:v>
                </c:pt>
                <c:pt idx="2">
                  <c:v>0.14901500000000001</c:v>
                </c:pt>
                <c:pt idx="3">
                  <c:v>0.149015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0BC-4DBB-8326-7FB223DFECDC}"/>
            </c:ext>
          </c:extLst>
        </c:ser>
        <c:ser>
          <c:idx val="5"/>
          <c:order val="5"/>
          <c:tx>
            <c:v>Lesion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A-S0021'!$E$48:$E$51</c:f>
              <c:numCache>
                <c:formatCode>General</c:formatCode>
                <c:ptCount val="4"/>
                <c:pt idx="0">
                  <c:v>0</c:v>
                </c:pt>
                <c:pt idx="1">
                  <c:v>130.65700000000001</c:v>
                </c:pt>
                <c:pt idx="2">
                  <c:v>195.55199999999999</c:v>
                </c:pt>
                <c:pt idx="3">
                  <c:v>195.55199999999999</c:v>
                </c:pt>
              </c:numCache>
            </c:numRef>
          </c:xVal>
          <c:yVal>
            <c:numRef>
              <c:f>'Patlak_10-88_cohort-A-S0021'!$F$48:$F$51</c:f>
              <c:numCache>
                <c:formatCode>General</c:formatCode>
                <c:ptCount val="4"/>
                <c:pt idx="0">
                  <c:v>0.23385</c:v>
                </c:pt>
                <c:pt idx="1">
                  <c:v>0.87787199999999999</c:v>
                </c:pt>
                <c:pt idx="2">
                  <c:v>1.1977500000000001</c:v>
                </c:pt>
                <c:pt idx="3">
                  <c:v>1.19775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0BC-4DBB-8326-7FB223DFEC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5033320"/>
        <c:axId val="401345872"/>
      </c:scatterChart>
      <c:valAx>
        <c:axId val="305033320"/>
        <c:scaling>
          <c:orientation val="minMax"/>
          <c:max val="2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Input Integral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01345872"/>
        <c:crosses val="autoZero"/>
        <c:crossBetween val="midCat"/>
        <c:majorUnit val="50"/>
      </c:valAx>
      <c:valAx>
        <c:axId val="401345872"/>
        <c:scaling>
          <c:orientation val="minMax"/>
          <c:max val="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Tissue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305033320"/>
        <c:crosses val="autoZero"/>
        <c:crossBetween val="midCat"/>
        <c:majorUnit val="0.5"/>
      </c:valAx>
      <c:spPr>
        <a:noFill/>
        <a:ln>
          <a:noFill/>
        </a:ln>
        <a:effectLst/>
      </c:spPr>
    </c:plotArea>
    <c:legend>
      <c:legendPos val="tr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1900767102580751"/>
          <c:y val="2.3378636378618634E-2"/>
          <c:w val="0.27175630116406446"/>
          <c:h val="0.202143672258359"/>
        </c:manualLayout>
      </c:layout>
      <c:overlay val="1"/>
      <c:spPr>
        <a:noFill/>
        <a:ln>
          <a:solidFill>
            <a:schemeClr val="bg1">
              <a:lumMod val="50000"/>
            </a:schemeClr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>
                <a:solidFill>
                  <a:schemeClr val="tx1"/>
                </a:solidFill>
              </a:rPr>
              <a:t>Cohort C</a:t>
            </a:r>
          </a:p>
        </c:rich>
      </c:tx>
      <c:layout>
        <c:manualLayout>
          <c:xMode val="edge"/>
          <c:yMode val="edge"/>
          <c:x val="4.4924109941709957E-2"/>
          <c:y val="2.2667017123655254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title>
    <c:autoTitleDeleted val="0"/>
    <c:plotArea>
      <c:layout>
        <c:manualLayout>
          <c:layoutTarget val="inner"/>
          <c:xMode val="edge"/>
          <c:yMode val="edge"/>
          <c:x val="0.14678249796521475"/>
          <c:y val="0.19746870889560691"/>
          <c:w val="0.80276798864740728"/>
          <c:h val="0.68037871892194468"/>
        </c:manualLayout>
      </c:layout>
      <c:scatterChart>
        <c:scatterStyle val="lineMarker"/>
        <c:varyColors val="0"/>
        <c:ser>
          <c:idx val="0"/>
          <c:order val="0"/>
          <c:tx>
            <c:strRef>
              <c:f>'Patlak_10-88_cohort-C-S0020'!$A$5</c:f>
              <c:strCache>
                <c:ptCount val="1"/>
                <c:pt idx="0">
                  <c:v>Bone Met 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Patlak_10-88_cohort-C-S0020'!$A$7:$A$25</c:f>
              <c:numCache>
                <c:formatCode>General</c:formatCode>
                <c:ptCount val="19"/>
                <c:pt idx="0">
                  <c:v>5.7735099999999999E-3</c:v>
                </c:pt>
                <c:pt idx="1">
                  <c:v>0.30271300000000001</c:v>
                </c:pt>
                <c:pt idx="2">
                  <c:v>0.93198300000000001</c:v>
                </c:pt>
                <c:pt idx="3">
                  <c:v>1.80775</c:v>
                </c:pt>
                <c:pt idx="4">
                  <c:v>2.5294699999999999</c:v>
                </c:pt>
                <c:pt idx="5">
                  <c:v>3.0411999999999999</c:v>
                </c:pt>
                <c:pt idx="6">
                  <c:v>3.4622299999999999</c:v>
                </c:pt>
                <c:pt idx="7">
                  <c:v>3.8586900000000002</c:v>
                </c:pt>
                <c:pt idx="8">
                  <c:v>4.6480100000000002</c:v>
                </c:pt>
                <c:pt idx="9">
                  <c:v>5.8669200000000004</c:v>
                </c:pt>
                <c:pt idx="10">
                  <c:v>8.1072500000000005</c:v>
                </c:pt>
                <c:pt idx="11">
                  <c:v>11.557499999999999</c:v>
                </c:pt>
                <c:pt idx="12">
                  <c:v>17.228400000000001</c:v>
                </c:pt>
                <c:pt idx="13">
                  <c:v>25.709599999999998</c:v>
                </c:pt>
                <c:pt idx="14">
                  <c:v>35.041600000000003</c:v>
                </c:pt>
                <c:pt idx="15">
                  <c:v>49.966900000000003</c:v>
                </c:pt>
                <c:pt idx="16">
                  <c:v>71.050600000000003</c:v>
                </c:pt>
                <c:pt idx="17">
                  <c:v>142.864</c:v>
                </c:pt>
                <c:pt idx="18">
                  <c:v>204.672</c:v>
                </c:pt>
              </c:numCache>
            </c:numRef>
          </c:xVal>
          <c:yVal>
            <c:numRef>
              <c:f>'Patlak_10-88_cohort-C-S0020'!$B$7:$B$25</c:f>
              <c:numCache>
                <c:formatCode>General</c:formatCode>
                <c:ptCount val="19"/>
                <c:pt idx="0">
                  <c:v>1.1144099999999999E-3</c:v>
                </c:pt>
                <c:pt idx="1">
                  <c:v>2.36835E-2</c:v>
                </c:pt>
                <c:pt idx="2">
                  <c:v>4.7886900000000003E-2</c:v>
                </c:pt>
                <c:pt idx="3">
                  <c:v>0.104364</c:v>
                </c:pt>
                <c:pt idx="4">
                  <c:v>0.113944</c:v>
                </c:pt>
                <c:pt idx="5">
                  <c:v>0.125305</c:v>
                </c:pt>
                <c:pt idx="6">
                  <c:v>0.16925299999999999</c:v>
                </c:pt>
                <c:pt idx="7">
                  <c:v>0.14957699999999999</c:v>
                </c:pt>
                <c:pt idx="8">
                  <c:v>0.185562</c:v>
                </c:pt>
                <c:pt idx="9">
                  <c:v>0.194075</c:v>
                </c:pt>
                <c:pt idx="10">
                  <c:v>0.25502900000000001</c:v>
                </c:pt>
                <c:pt idx="11">
                  <c:v>0.33770099999999997</c:v>
                </c:pt>
                <c:pt idx="12">
                  <c:v>0.44452000000000003</c:v>
                </c:pt>
                <c:pt idx="13">
                  <c:v>0.59340000000000004</c:v>
                </c:pt>
                <c:pt idx="14">
                  <c:v>0.74100600000000005</c:v>
                </c:pt>
                <c:pt idx="15">
                  <c:v>0.94899900000000004</c:v>
                </c:pt>
                <c:pt idx="16">
                  <c:v>1.20916</c:v>
                </c:pt>
                <c:pt idx="17">
                  <c:v>1.7433000000000001</c:v>
                </c:pt>
                <c:pt idx="18">
                  <c:v>2.57765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B45-41F8-9AAE-7EE943B80722}"/>
            </c:ext>
          </c:extLst>
        </c:ser>
        <c:ser>
          <c:idx val="1"/>
          <c:order val="1"/>
          <c:tx>
            <c:v>Bone Met 1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6:$E$9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6:$F$9</c:f>
              <c:numCache>
                <c:formatCode>General</c:formatCode>
                <c:ptCount val="4"/>
                <c:pt idx="0">
                  <c:v>0.37167699999999998</c:v>
                </c:pt>
                <c:pt idx="1">
                  <c:v>1.8135699999999999</c:v>
                </c:pt>
                <c:pt idx="2">
                  <c:v>2.4373800000000001</c:v>
                </c:pt>
                <c:pt idx="3">
                  <c:v>2.43738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B45-41F8-9AAE-7EE943B80722}"/>
            </c:ext>
          </c:extLst>
        </c:ser>
        <c:ser>
          <c:idx val="2"/>
          <c:order val="2"/>
          <c:tx>
            <c:strRef>
              <c:f>'Patlak_10-88_cohort-C-S0020'!$A$26</c:f>
              <c:strCache>
                <c:ptCount val="1"/>
                <c:pt idx="0">
                  <c:v>Bone Met 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Patlak_10-88_cohort-C-S0020'!$A$27:$A$46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27:$B$46</c:f>
              <c:numCache>
                <c:formatCode>General</c:formatCode>
                <c:ptCount val="20"/>
                <c:pt idx="0">
                  <c:v>0</c:v>
                </c:pt>
                <c:pt idx="1">
                  <c:v>6.0294299999999997E-3</c:v>
                </c:pt>
                <c:pt idx="2">
                  <c:v>2.94957E-2</c:v>
                </c:pt>
                <c:pt idx="3">
                  <c:v>8.1193299999999996E-2</c:v>
                </c:pt>
                <c:pt idx="4">
                  <c:v>0.135963</c:v>
                </c:pt>
                <c:pt idx="5">
                  <c:v>0.19503000000000001</c:v>
                </c:pt>
                <c:pt idx="6">
                  <c:v>0.18621499999999999</c:v>
                </c:pt>
                <c:pt idx="7">
                  <c:v>0.165883</c:v>
                </c:pt>
                <c:pt idx="8">
                  <c:v>0.18845000000000001</c:v>
                </c:pt>
                <c:pt idx="9">
                  <c:v>0.22589899999999999</c:v>
                </c:pt>
                <c:pt idx="10">
                  <c:v>0.236567</c:v>
                </c:pt>
                <c:pt idx="11">
                  <c:v>0.277841</c:v>
                </c:pt>
                <c:pt idx="12">
                  <c:v>0.31216899999999997</c:v>
                </c:pt>
                <c:pt idx="13">
                  <c:v>0.39830900000000002</c:v>
                </c:pt>
                <c:pt idx="14">
                  <c:v>0.49923600000000001</c:v>
                </c:pt>
                <c:pt idx="15">
                  <c:v>0.63984399999999997</c:v>
                </c:pt>
                <c:pt idx="16">
                  <c:v>0.83429299999999995</c:v>
                </c:pt>
                <c:pt idx="17">
                  <c:v>1.04664</c:v>
                </c:pt>
                <c:pt idx="18">
                  <c:v>2.0139399999999998</c:v>
                </c:pt>
                <c:pt idx="19">
                  <c:v>2.445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B45-41F8-9AAE-7EE943B80722}"/>
            </c:ext>
          </c:extLst>
        </c:ser>
        <c:ser>
          <c:idx val="3"/>
          <c:order val="3"/>
          <c:tx>
            <c:v>Bone Met 2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27:$E$30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27:$F$30</c:f>
              <c:numCache>
                <c:formatCode>General</c:formatCode>
                <c:ptCount val="4"/>
                <c:pt idx="0">
                  <c:v>0.17663200000000001</c:v>
                </c:pt>
                <c:pt idx="1">
                  <c:v>2.0038900000000002</c:v>
                </c:pt>
                <c:pt idx="2">
                  <c:v>2.7944300000000002</c:v>
                </c:pt>
                <c:pt idx="3">
                  <c:v>2.79443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B45-41F8-9AAE-7EE943B80722}"/>
            </c:ext>
          </c:extLst>
        </c:ser>
        <c:ser>
          <c:idx val="4"/>
          <c:order val="4"/>
          <c:tx>
            <c:strRef>
              <c:f>'Patlak_10-88_cohort-C-S0020'!$A$47</c:f>
              <c:strCache>
                <c:ptCount val="1"/>
                <c:pt idx="0">
                  <c:v>Bone Met 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48:$A$67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48:$B$67</c:f>
              <c:numCache>
                <c:formatCode>General</c:formatCode>
                <c:ptCount val="20"/>
                <c:pt idx="0">
                  <c:v>0</c:v>
                </c:pt>
                <c:pt idx="1">
                  <c:v>3.9144799999999997E-3</c:v>
                </c:pt>
                <c:pt idx="2">
                  <c:v>5.9186799999999998E-2</c:v>
                </c:pt>
                <c:pt idx="3">
                  <c:v>6.5974099999999994E-2</c:v>
                </c:pt>
                <c:pt idx="4">
                  <c:v>0.19922100000000001</c:v>
                </c:pt>
                <c:pt idx="5">
                  <c:v>0.19419900000000001</c:v>
                </c:pt>
                <c:pt idx="6">
                  <c:v>0.23947299999999999</c:v>
                </c:pt>
                <c:pt idx="7">
                  <c:v>0.21712400000000001</c:v>
                </c:pt>
                <c:pt idx="8">
                  <c:v>0.23216300000000001</c:v>
                </c:pt>
                <c:pt idx="9">
                  <c:v>0.243618</c:v>
                </c:pt>
                <c:pt idx="10">
                  <c:v>0.26214599999999999</c:v>
                </c:pt>
                <c:pt idx="11">
                  <c:v>0.26340400000000003</c:v>
                </c:pt>
                <c:pt idx="12">
                  <c:v>0.326762</c:v>
                </c:pt>
                <c:pt idx="13">
                  <c:v>0.39282400000000001</c:v>
                </c:pt>
                <c:pt idx="14">
                  <c:v>0.557006</c:v>
                </c:pt>
                <c:pt idx="15">
                  <c:v>0.68150299999999997</c:v>
                </c:pt>
                <c:pt idx="16">
                  <c:v>0.82857000000000003</c:v>
                </c:pt>
                <c:pt idx="17">
                  <c:v>1.07334</c:v>
                </c:pt>
                <c:pt idx="18">
                  <c:v>1.7373700000000001</c:v>
                </c:pt>
                <c:pt idx="19">
                  <c:v>1.993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B45-41F8-9AAE-7EE943B80722}"/>
            </c:ext>
          </c:extLst>
        </c:ser>
        <c:ser>
          <c:idx val="5"/>
          <c:order val="5"/>
          <c:tx>
            <c:v>Bone Met 3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48:$E$51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48:$F$51</c:f>
              <c:numCache>
                <c:formatCode>General</c:formatCode>
                <c:ptCount val="4"/>
                <c:pt idx="0">
                  <c:v>0.287769</c:v>
                </c:pt>
                <c:pt idx="1">
                  <c:v>1.76881</c:v>
                </c:pt>
                <c:pt idx="2">
                  <c:v>2.4095599999999999</c:v>
                </c:pt>
                <c:pt idx="3">
                  <c:v>2.40955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B45-41F8-9AAE-7EE943B80722}"/>
            </c:ext>
          </c:extLst>
        </c:ser>
        <c:ser>
          <c:idx val="6"/>
          <c:order val="6"/>
          <c:tx>
            <c:strRef>
              <c:f>'Patlak_10-88_cohort-C-S0020'!$A$68</c:f>
              <c:strCache>
                <c:ptCount val="1"/>
                <c:pt idx="0">
                  <c:v>Bone Met 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Patlak_10-88_cohort-C-S0020'!$A$69:$A$88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69:$B$88</c:f>
              <c:numCache>
                <c:formatCode>General</c:formatCode>
                <c:ptCount val="20"/>
                <c:pt idx="0">
                  <c:v>0</c:v>
                </c:pt>
                <c:pt idx="1">
                  <c:v>2.4258499999999998E-3</c:v>
                </c:pt>
                <c:pt idx="2">
                  <c:v>4.1065200000000003E-2</c:v>
                </c:pt>
                <c:pt idx="3">
                  <c:v>7.4993099999999993E-2</c:v>
                </c:pt>
                <c:pt idx="4">
                  <c:v>0.102307</c:v>
                </c:pt>
                <c:pt idx="5">
                  <c:v>0.18731600000000001</c:v>
                </c:pt>
                <c:pt idx="6">
                  <c:v>0.23876700000000001</c:v>
                </c:pt>
                <c:pt idx="7">
                  <c:v>0.23494999999999999</c:v>
                </c:pt>
                <c:pt idx="8">
                  <c:v>0.19930400000000001</c:v>
                </c:pt>
                <c:pt idx="9">
                  <c:v>0.19189600000000001</c:v>
                </c:pt>
                <c:pt idx="10">
                  <c:v>0.221137</c:v>
                </c:pt>
                <c:pt idx="11">
                  <c:v>0.23823</c:v>
                </c:pt>
                <c:pt idx="12">
                  <c:v>0.288074</c:v>
                </c:pt>
                <c:pt idx="13">
                  <c:v>0.35454400000000003</c:v>
                </c:pt>
                <c:pt idx="14">
                  <c:v>0.43094300000000002</c:v>
                </c:pt>
                <c:pt idx="15">
                  <c:v>0.57960999999999996</c:v>
                </c:pt>
                <c:pt idx="16">
                  <c:v>0.72566299999999995</c:v>
                </c:pt>
                <c:pt idx="17">
                  <c:v>0.927732</c:v>
                </c:pt>
                <c:pt idx="18">
                  <c:v>1.6139399999999999</c:v>
                </c:pt>
                <c:pt idx="19">
                  <c:v>2.180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B45-41F8-9AAE-7EE943B80722}"/>
            </c:ext>
          </c:extLst>
        </c:ser>
        <c:ser>
          <c:idx val="7"/>
          <c:order val="7"/>
          <c:tx>
            <c:v>Bone Met 4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69:$E$72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69:$F$72</c:f>
              <c:numCache>
                <c:formatCode>General</c:formatCode>
                <c:ptCount val="4"/>
                <c:pt idx="0">
                  <c:v>0.204014</c:v>
                </c:pt>
                <c:pt idx="1">
                  <c:v>1.62836</c:v>
                </c:pt>
                <c:pt idx="2">
                  <c:v>2.2445900000000001</c:v>
                </c:pt>
                <c:pt idx="3">
                  <c:v>2.24459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B45-41F8-9AAE-7EE943B80722}"/>
            </c:ext>
          </c:extLst>
        </c:ser>
        <c:ser>
          <c:idx val="8"/>
          <c:order val="8"/>
          <c:tx>
            <c:strRef>
              <c:f>'Patlak_10-88_cohort-C-S0020'!$A$89</c:f>
              <c:strCache>
                <c:ptCount val="1"/>
                <c:pt idx="0">
                  <c:v>LN Met 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Patlak_10-88_cohort-C-S0020'!$A$90:$A$109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90:$B$109</c:f>
              <c:numCache>
                <c:formatCode>General</c:formatCode>
                <c:ptCount val="20"/>
                <c:pt idx="0">
                  <c:v>0</c:v>
                </c:pt>
                <c:pt idx="1">
                  <c:v>2.4967000000000001E-3</c:v>
                </c:pt>
                <c:pt idx="2">
                  <c:v>0.161583</c:v>
                </c:pt>
                <c:pt idx="3">
                  <c:v>0.176792</c:v>
                </c:pt>
                <c:pt idx="4">
                  <c:v>0.29010399999999997</c:v>
                </c:pt>
                <c:pt idx="5">
                  <c:v>0.39244899999999999</c:v>
                </c:pt>
                <c:pt idx="6">
                  <c:v>0.43761699999999998</c:v>
                </c:pt>
                <c:pt idx="7">
                  <c:v>0.41442899999999999</c:v>
                </c:pt>
                <c:pt idx="8">
                  <c:v>0.458173</c:v>
                </c:pt>
                <c:pt idx="9">
                  <c:v>0.47781699999999999</c:v>
                </c:pt>
                <c:pt idx="10">
                  <c:v>0.51169399999999998</c:v>
                </c:pt>
                <c:pt idx="11">
                  <c:v>0.55846799999999996</c:v>
                </c:pt>
                <c:pt idx="12">
                  <c:v>0.65732199999999996</c:v>
                </c:pt>
                <c:pt idx="13">
                  <c:v>0.79701100000000002</c:v>
                </c:pt>
                <c:pt idx="14">
                  <c:v>0.999637</c:v>
                </c:pt>
                <c:pt idx="15">
                  <c:v>1.21851</c:v>
                </c:pt>
                <c:pt idx="16">
                  <c:v>1.50173</c:v>
                </c:pt>
                <c:pt idx="17">
                  <c:v>1.81559</c:v>
                </c:pt>
                <c:pt idx="18">
                  <c:v>3.3634300000000001</c:v>
                </c:pt>
                <c:pt idx="19">
                  <c:v>4.31986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7B45-41F8-9AAE-7EE943B80722}"/>
            </c:ext>
          </c:extLst>
        </c:ser>
        <c:ser>
          <c:idx val="9"/>
          <c:order val="9"/>
          <c:tx>
            <c:v>LN Met 1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90:$E$93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90:$F$93</c:f>
              <c:numCache>
                <c:formatCode>General</c:formatCode>
                <c:ptCount val="4"/>
                <c:pt idx="0">
                  <c:v>0.47118599999999999</c:v>
                </c:pt>
                <c:pt idx="1">
                  <c:v>3.3416600000000001</c:v>
                </c:pt>
                <c:pt idx="2">
                  <c:v>4.5835299999999997</c:v>
                </c:pt>
                <c:pt idx="3">
                  <c:v>4.58352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B45-41F8-9AAE-7EE943B80722}"/>
            </c:ext>
          </c:extLst>
        </c:ser>
        <c:ser>
          <c:idx val="10"/>
          <c:order val="10"/>
          <c:tx>
            <c:strRef>
              <c:f>'Patlak_10-88_cohort-C-S0020'!$A$110</c:f>
              <c:strCache>
                <c:ptCount val="1"/>
                <c:pt idx="0">
                  <c:v>LN Met 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111:$A$130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111:$B$130</c:f>
              <c:numCache>
                <c:formatCode>General</c:formatCode>
                <c:ptCount val="20"/>
                <c:pt idx="0">
                  <c:v>0</c:v>
                </c:pt>
                <c:pt idx="1">
                  <c:v>4.5532799999999998E-3</c:v>
                </c:pt>
                <c:pt idx="2">
                  <c:v>0.10288600000000001</c:v>
                </c:pt>
                <c:pt idx="3">
                  <c:v>0.160525</c:v>
                </c:pt>
                <c:pt idx="4">
                  <c:v>0.22906899999999999</c:v>
                </c:pt>
                <c:pt idx="5">
                  <c:v>0.29294300000000001</c:v>
                </c:pt>
                <c:pt idx="6">
                  <c:v>0.33741100000000002</c:v>
                </c:pt>
                <c:pt idx="7">
                  <c:v>0.36643900000000001</c:v>
                </c:pt>
                <c:pt idx="8">
                  <c:v>0.39110800000000001</c:v>
                </c:pt>
                <c:pt idx="9">
                  <c:v>0.44952300000000001</c:v>
                </c:pt>
                <c:pt idx="10">
                  <c:v>0.50101300000000004</c:v>
                </c:pt>
                <c:pt idx="11">
                  <c:v>0.64631700000000003</c:v>
                </c:pt>
                <c:pt idx="12">
                  <c:v>0.81772800000000001</c:v>
                </c:pt>
                <c:pt idx="13">
                  <c:v>1.08222</c:v>
                </c:pt>
                <c:pt idx="14">
                  <c:v>1.4279299999999999</c:v>
                </c:pt>
                <c:pt idx="15">
                  <c:v>1.7872699999999999</c:v>
                </c:pt>
                <c:pt idx="16">
                  <c:v>2.3016700000000001</c:v>
                </c:pt>
                <c:pt idx="17">
                  <c:v>2.88686</c:v>
                </c:pt>
                <c:pt idx="18">
                  <c:v>4.6299299999999999</c:v>
                </c:pt>
                <c:pt idx="19">
                  <c:v>5.8414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7B45-41F8-9AAE-7EE943B80722}"/>
            </c:ext>
          </c:extLst>
        </c:ser>
        <c:ser>
          <c:idx val="11"/>
          <c:order val="11"/>
          <c:tx>
            <c:v>LN Met 2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111:$E$114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111:$F$114</c:f>
              <c:numCache>
                <c:formatCode>General</c:formatCode>
                <c:ptCount val="4"/>
                <c:pt idx="0">
                  <c:v>0.77479299999999995</c:v>
                </c:pt>
                <c:pt idx="1">
                  <c:v>4.7311199999999998</c:v>
                </c:pt>
                <c:pt idx="2">
                  <c:v>6.4427700000000003</c:v>
                </c:pt>
                <c:pt idx="3">
                  <c:v>6.44277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7B45-41F8-9AAE-7EE943B80722}"/>
            </c:ext>
          </c:extLst>
        </c:ser>
        <c:ser>
          <c:idx val="12"/>
          <c:order val="12"/>
          <c:tx>
            <c:strRef>
              <c:f>'Patlak_10-88_cohort-C-S0020'!$A$131</c:f>
              <c:strCache>
                <c:ptCount val="1"/>
                <c:pt idx="0">
                  <c:v>LN Met 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132:$A$151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132:$B$151</c:f>
              <c:numCache>
                <c:formatCode>General</c:formatCode>
                <c:ptCount val="20"/>
                <c:pt idx="0">
                  <c:v>0</c:v>
                </c:pt>
                <c:pt idx="1">
                  <c:v>1.0108199999999999E-2</c:v>
                </c:pt>
                <c:pt idx="2">
                  <c:v>0.211535</c:v>
                </c:pt>
                <c:pt idx="3">
                  <c:v>0.20935300000000001</c:v>
                </c:pt>
                <c:pt idx="4">
                  <c:v>0.25517200000000001</c:v>
                </c:pt>
                <c:pt idx="5">
                  <c:v>0.32036300000000001</c:v>
                </c:pt>
                <c:pt idx="6">
                  <c:v>0.368946</c:v>
                </c:pt>
                <c:pt idx="7">
                  <c:v>0.43127300000000002</c:v>
                </c:pt>
                <c:pt idx="8">
                  <c:v>0.35590300000000002</c:v>
                </c:pt>
                <c:pt idx="9">
                  <c:v>0.39694600000000002</c:v>
                </c:pt>
                <c:pt idx="10">
                  <c:v>0.43073499999999998</c:v>
                </c:pt>
                <c:pt idx="11">
                  <c:v>0.48938799999999999</c:v>
                </c:pt>
                <c:pt idx="12">
                  <c:v>0.54546399999999995</c:v>
                </c:pt>
                <c:pt idx="13">
                  <c:v>0.697689</c:v>
                </c:pt>
                <c:pt idx="14">
                  <c:v>0.875251</c:v>
                </c:pt>
                <c:pt idx="15">
                  <c:v>1.05748</c:v>
                </c:pt>
                <c:pt idx="16">
                  <c:v>1.3214900000000001</c:v>
                </c:pt>
                <c:pt idx="17">
                  <c:v>1.62781</c:v>
                </c:pt>
                <c:pt idx="18">
                  <c:v>2.1169099999999998</c:v>
                </c:pt>
                <c:pt idx="19">
                  <c:v>2.73687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7B45-41F8-9AAE-7EE943B80722}"/>
            </c:ext>
          </c:extLst>
        </c:ser>
        <c:ser>
          <c:idx val="13"/>
          <c:order val="13"/>
          <c:tx>
            <c:v>LN Met 3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132:$E$135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132:$F$135</c:f>
              <c:numCache>
                <c:formatCode>General</c:formatCode>
                <c:ptCount val="4"/>
                <c:pt idx="0">
                  <c:v>0.65667900000000001</c:v>
                </c:pt>
                <c:pt idx="1">
                  <c:v>2.22655</c:v>
                </c:pt>
                <c:pt idx="2">
                  <c:v>2.9057300000000001</c:v>
                </c:pt>
                <c:pt idx="3">
                  <c:v>2.90573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7B45-41F8-9AAE-7EE943B80722}"/>
            </c:ext>
          </c:extLst>
        </c:ser>
        <c:ser>
          <c:idx val="14"/>
          <c:order val="14"/>
          <c:tx>
            <c:strRef>
              <c:f>'Patlak_10-88_cohort-C-S0020'!$A$152</c:f>
              <c:strCache>
                <c:ptCount val="1"/>
                <c:pt idx="0">
                  <c:v>LN Met 4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153:$A$172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153:$B$172</c:f>
              <c:numCache>
                <c:formatCode>General</c:formatCode>
                <c:ptCount val="20"/>
                <c:pt idx="0">
                  <c:v>0</c:v>
                </c:pt>
                <c:pt idx="1">
                  <c:v>2.62663E-3</c:v>
                </c:pt>
                <c:pt idx="2">
                  <c:v>9.6048599999999998E-2</c:v>
                </c:pt>
                <c:pt idx="3">
                  <c:v>0.157494</c:v>
                </c:pt>
                <c:pt idx="4">
                  <c:v>0.197798</c:v>
                </c:pt>
                <c:pt idx="5">
                  <c:v>0.25322800000000001</c:v>
                </c:pt>
                <c:pt idx="6">
                  <c:v>0.30490099999999998</c:v>
                </c:pt>
                <c:pt idx="7">
                  <c:v>0.29803000000000002</c:v>
                </c:pt>
                <c:pt idx="8">
                  <c:v>0.31082300000000002</c:v>
                </c:pt>
                <c:pt idx="9">
                  <c:v>0.34692499999999998</c:v>
                </c:pt>
                <c:pt idx="10">
                  <c:v>0.42443500000000001</c:v>
                </c:pt>
                <c:pt idx="11">
                  <c:v>0.51837800000000001</c:v>
                </c:pt>
                <c:pt idx="12">
                  <c:v>0.67155799999999999</c:v>
                </c:pt>
                <c:pt idx="13">
                  <c:v>0.86505100000000001</c:v>
                </c:pt>
                <c:pt idx="14">
                  <c:v>1.15689</c:v>
                </c:pt>
                <c:pt idx="15">
                  <c:v>1.4749699999999999</c:v>
                </c:pt>
                <c:pt idx="16">
                  <c:v>1.877</c:v>
                </c:pt>
                <c:pt idx="17">
                  <c:v>2.4386700000000001</c:v>
                </c:pt>
                <c:pt idx="18">
                  <c:v>3.7562600000000002</c:v>
                </c:pt>
                <c:pt idx="19">
                  <c:v>4.71346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7B45-41F8-9AAE-7EE943B80722}"/>
            </c:ext>
          </c:extLst>
        </c:ser>
        <c:ser>
          <c:idx val="15"/>
          <c:order val="15"/>
          <c:tx>
            <c:v>LN Met 4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153:$E$156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153:$F$156</c:f>
              <c:numCache>
                <c:formatCode>General</c:formatCode>
                <c:ptCount val="4"/>
                <c:pt idx="0">
                  <c:v>0.64103600000000005</c:v>
                </c:pt>
                <c:pt idx="1">
                  <c:v>3.8683299999999998</c:v>
                </c:pt>
                <c:pt idx="2">
                  <c:v>5.26457</c:v>
                </c:pt>
                <c:pt idx="3">
                  <c:v>5.264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7B45-41F8-9AAE-7EE943B80722}"/>
            </c:ext>
          </c:extLst>
        </c:ser>
        <c:ser>
          <c:idx val="16"/>
          <c:order val="16"/>
          <c:tx>
            <c:strRef>
              <c:f>'Patlak_10-88_cohort-C-S0020'!$A$173</c:f>
              <c:strCache>
                <c:ptCount val="1"/>
                <c:pt idx="0">
                  <c:v>LN Met 5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174:$A$193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174:$B$193</c:f>
              <c:numCache>
                <c:formatCode>General</c:formatCode>
                <c:ptCount val="20"/>
                <c:pt idx="0">
                  <c:v>0</c:v>
                </c:pt>
                <c:pt idx="1">
                  <c:v>2.6040500000000001E-2</c:v>
                </c:pt>
                <c:pt idx="2">
                  <c:v>0.15176000000000001</c:v>
                </c:pt>
                <c:pt idx="3">
                  <c:v>0.18193100000000001</c:v>
                </c:pt>
                <c:pt idx="4">
                  <c:v>0.29385800000000001</c:v>
                </c:pt>
                <c:pt idx="5">
                  <c:v>0.34445199999999998</c:v>
                </c:pt>
                <c:pt idx="6">
                  <c:v>0.42475499999999999</c:v>
                </c:pt>
                <c:pt idx="7">
                  <c:v>0.40815000000000001</c:v>
                </c:pt>
                <c:pt idx="8">
                  <c:v>0.41197299999999998</c:v>
                </c:pt>
                <c:pt idx="9">
                  <c:v>0.46509400000000001</c:v>
                </c:pt>
                <c:pt idx="10">
                  <c:v>0.479072</c:v>
                </c:pt>
                <c:pt idx="11">
                  <c:v>0.60970899999999995</c:v>
                </c:pt>
                <c:pt idx="12">
                  <c:v>0.74696899999999999</c:v>
                </c:pt>
                <c:pt idx="13">
                  <c:v>0.99487999999999999</c:v>
                </c:pt>
                <c:pt idx="14">
                  <c:v>1.3548100000000001</c:v>
                </c:pt>
                <c:pt idx="15">
                  <c:v>1.6123499999999999</c:v>
                </c:pt>
                <c:pt idx="16">
                  <c:v>2.04216</c:v>
                </c:pt>
                <c:pt idx="17">
                  <c:v>2.6920799999999998</c:v>
                </c:pt>
                <c:pt idx="18">
                  <c:v>3.8479100000000002</c:v>
                </c:pt>
                <c:pt idx="19">
                  <c:v>5.07565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0-7B45-41F8-9AAE-7EE943B80722}"/>
            </c:ext>
          </c:extLst>
        </c:ser>
        <c:ser>
          <c:idx val="17"/>
          <c:order val="17"/>
          <c:tx>
            <c:v>LN Met 5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174:$E$177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174:$F$177</c:f>
              <c:numCache>
                <c:formatCode>General</c:formatCode>
                <c:ptCount val="4"/>
                <c:pt idx="0">
                  <c:v>0.82540899999999995</c:v>
                </c:pt>
                <c:pt idx="1">
                  <c:v>3.9980099999999998</c:v>
                </c:pt>
                <c:pt idx="2">
                  <c:v>5.3705800000000004</c:v>
                </c:pt>
                <c:pt idx="3">
                  <c:v>5.37058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7B45-41F8-9AAE-7EE943B80722}"/>
            </c:ext>
          </c:extLst>
        </c:ser>
        <c:ser>
          <c:idx val="18"/>
          <c:order val="18"/>
          <c:tx>
            <c:strRef>
              <c:f>'Patlak_10-88_cohort-C-S0020'!$A$194</c:f>
              <c:strCache>
                <c:ptCount val="1"/>
                <c:pt idx="0">
                  <c:v>LN Met 6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195:$A$214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195:$B$214</c:f>
              <c:numCache>
                <c:formatCode>General</c:formatCode>
                <c:ptCount val="20"/>
                <c:pt idx="0">
                  <c:v>0</c:v>
                </c:pt>
                <c:pt idx="1">
                  <c:v>6.8161699999999999E-3</c:v>
                </c:pt>
                <c:pt idx="2">
                  <c:v>0.145482</c:v>
                </c:pt>
                <c:pt idx="3">
                  <c:v>0.20053099999999999</c:v>
                </c:pt>
                <c:pt idx="4">
                  <c:v>0.27643000000000001</c:v>
                </c:pt>
                <c:pt idx="5">
                  <c:v>0.40069900000000003</c:v>
                </c:pt>
                <c:pt idx="6">
                  <c:v>0.481931</c:v>
                </c:pt>
                <c:pt idx="7">
                  <c:v>0.493448</c:v>
                </c:pt>
                <c:pt idx="8">
                  <c:v>0.53992499999999999</c:v>
                </c:pt>
                <c:pt idx="9">
                  <c:v>0.58631599999999995</c:v>
                </c:pt>
                <c:pt idx="10">
                  <c:v>0.73358199999999996</c:v>
                </c:pt>
                <c:pt idx="11">
                  <c:v>0.83992999999999995</c:v>
                </c:pt>
                <c:pt idx="12">
                  <c:v>1.12107</c:v>
                </c:pt>
                <c:pt idx="13">
                  <c:v>1.4993799999999999</c:v>
                </c:pt>
                <c:pt idx="14">
                  <c:v>2.0160999999999998</c:v>
                </c:pt>
                <c:pt idx="15">
                  <c:v>2.4428399999999999</c:v>
                </c:pt>
                <c:pt idx="16">
                  <c:v>3.2104200000000001</c:v>
                </c:pt>
                <c:pt idx="17">
                  <c:v>4.0777999999999999</c:v>
                </c:pt>
                <c:pt idx="18">
                  <c:v>6.3236699999999999</c:v>
                </c:pt>
                <c:pt idx="19">
                  <c:v>7.72993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2-7B45-41F8-9AAE-7EE943B80722}"/>
            </c:ext>
          </c:extLst>
        </c:ser>
        <c:ser>
          <c:idx val="19"/>
          <c:order val="19"/>
          <c:tx>
            <c:v>LN Met 6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195:$E$198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195:$F$198</c:f>
              <c:numCache>
                <c:formatCode>General</c:formatCode>
                <c:ptCount val="4"/>
                <c:pt idx="0">
                  <c:v>1.1147</c:v>
                </c:pt>
                <c:pt idx="1">
                  <c:v>6.4981099999999996</c:v>
                </c:pt>
                <c:pt idx="2">
                  <c:v>8.8271599999999992</c:v>
                </c:pt>
                <c:pt idx="3">
                  <c:v>8.82715999999999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7B45-41F8-9AAE-7EE943B80722}"/>
            </c:ext>
          </c:extLst>
        </c:ser>
        <c:ser>
          <c:idx val="20"/>
          <c:order val="20"/>
          <c:tx>
            <c:strRef>
              <c:f>'Patlak_10-88_cohort-C-S0020'!$A$215</c:f>
              <c:strCache>
                <c:ptCount val="1"/>
                <c:pt idx="0">
                  <c:v>Bone (Reference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Patlak_10-88_cohort-C-S0020'!$A$216:$A$235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216:$B$235</c:f>
              <c:numCache>
                <c:formatCode>General</c:formatCode>
                <c:ptCount val="20"/>
                <c:pt idx="0">
                  <c:v>0</c:v>
                </c:pt>
                <c:pt idx="1">
                  <c:v>9.3385300000000001E-4</c:v>
                </c:pt>
                <c:pt idx="2">
                  <c:v>4.5422099999999997E-3</c:v>
                </c:pt>
                <c:pt idx="3">
                  <c:v>1.7540900000000002E-2</c:v>
                </c:pt>
                <c:pt idx="4">
                  <c:v>3.9105000000000001E-2</c:v>
                </c:pt>
                <c:pt idx="5">
                  <c:v>5.1335199999999997E-2</c:v>
                </c:pt>
                <c:pt idx="6">
                  <c:v>6.1711099999999998E-2</c:v>
                </c:pt>
                <c:pt idx="7">
                  <c:v>5.4733799999999999E-2</c:v>
                </c:pt>
                <c:pt idx="8">
                  <c:v>6.3737299999999997E-2</c:v>
                </c:pt>
                <c:pt idx="9">
                  <c:v>5.87996E-2</c:v>
                </c:pt>
                <c:pt idx="10">
                  <c:v>7.1766300000000005E-2</c:v>
                </c:pt>
                <c:pt idx="11">
                  <c:v>6.8040799999999999E-2</c:v>
                </c:pt>
                <c:pt idx="12">
                  <c:v>7.6828800000000003E-2</c:v>
                </c:pt>
                <c:pt idx="13">
                  <c:v>8.2653500000000005E-2</c:v>
                </c:pt>
                <c:pt idx="14">
                  <c:v>8.6217100000000005E-2</c:v>
                </c:pt>
                <c:pt idx="15">
                  <c:v>9.8105200000000004E-2</c:v>
                </c:pt>
                <c:pt idx="16">
                  <c:v>0.10573299999999999</c:v>
                </c:pt>
                <c:pt idx="17">
                  <c:v>0.119697</c:v>
                </c:pt>
                <c:pt idx="18">
                  <c:v>0.16906599999999999</c:v>
                </c:pt>
                <c:pt idx="19">
                  <c:v>0.233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4-7B45-41F8-9AAE-7EE943B80722}"/>
            </c:ext>
          </c:extLst>
        </c:ser>
        <c:ser>
          <c:idx val="21"/>
          <c:order val="21"/>
          <c:tx>
            <c:v>Bon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216:$E$219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216:$F$219</c:f>
              <c:numCache>
                <c:formatCode>General</c:formatCode>
                <c:ptCount val="4"/>
                <c:pt idx="0">
                  <c:v>7.1071700000000002E-2</c:v>
                </c:pt>
                <c:pt idx="1">
                  <c:v>0.169296</c:v>
                </c:pt>
                <c:pt idx="2">
                  <c:v>0.21179100000000001</c:v>
                </c:pt>
                <c:pt idx="3">
                  <c:v>0.21179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7B45-41F8-9AAE-7EE943B80722}"/>
            </c:ext>
          </c:extLst>
        </c:ser>
        <c:ser>
          <c:idx val="22"/>
          <c:order val="22"/>
          <c:tx>
            <c:strRef>
              <c:f>'Patlak_10-88_cohort-C-S0020'!$A$236</c:f>
              <c:strCache>
                <c:ptCount val="1"/>
                <c:pt idx="0">
                  <c:v>Liver (Reference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xVal>
            <c:numRef>
              <c:f>'Patlak_10-88_cohort-C-S0020'!$A$237:$A$256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237:$B$256</c:f>
              <c:numCache>
                <c:formatCode>0.00E+00</c:formatCode>
                <c:ptCount val="20"/>
                <c:pt idx="0" formatCode="General">
                  <c:v>0</c:v>
                </c:pt>
                <c:pt idx="1">
                  <c:v>6.32073E-5</c:v>
                </c:pt>
                <c:pt idx="2" formatCode="General">
                  <c:v>3.17758E-2</c:v>
                </c:pt>
                <c:pt idx="3" formatCode="General">
                  <c:v>0.13419600000000001</c:v>
                </c:pt>
                <c:pt idx="4" formatCode="General">
                  <c:v>0.23369200000000001</c:v>
                </c:pt>
                <c:pt idx="5" formatCode="General">
                  <c:v>0.25973299999999999</c:v>
                </c:pt>
                <c:pt idx="6" formatCode="General">
                  <c:v>0.218445</c:v>
                </c:pt>
                <c:pt idx="7" formatCode="General">
                  <c:v>0.154366</c:v>
                </c:pt>
                <c:pt idx="8" formatCode="General">
                  <c:v>0.20753199999999999</c:v>
                </c:pt>
                <c:pt idx="9" formatCode="General">
                  <c:v>0.25183800000000001</c:v>
                </c:pt>
                <c:pt idx="10" formatCode="General">
                  <c:v>0.288553</c:v>
                </c:pt>
                <c:pt idx="11" formatCode="General">
                  <c:v>0.31247399999999997</c:v>
                </c:pt>
                <c:pt idx="12" formatCode="General">
                  <c:v>0.39145200000000002</c:v>
                </c:pt>
                <c:pt idx="13" formatCode="General">
                  <c:v>0.44648700000000002</c:v>
                </c:pt>
                <c:pt idx="14" formatCode="General">
                  <c:v>0.41592200000000001</c:v>
                </c:pt>
                <c:pt idx="15" formatCode="General">
                  <c:v>0.64378000000000002</c:v>
                </c:pt>
                <c:pt idx="16" formatCode="General">
                  <c:v>0.79145900000000002</c:v>
                </c:pt>
                <c:pt idx="17" formatCode="General">
                  <c:v>1.26583</c:v>
                </c:pt>
                <c:pt idx="18" formatCode="General">
                  <c:v>2.3322400000000001</c:v>
                </c:pt>
                <c:pt idx="19" formatCode="General">
                  <c:v>1.99791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6-7B45-41F8-9AAE-7EE943B80722}"/>
            </c:ext>
          </c:extLst>
        </c:ser>
        <c:ser>
          <c:idx val="23"/>
          <c:order val="23"/>
          <c:tx>
            <c:v>Liver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237:$E$240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237:$F$240</c:f>
              <c:numCache>
                <c:formatCode>General</c:formatCode>
                <c:ptCount val="4"/>
                <c:pt idx="0">
                  <c:v>8.6475999999999997E-2</c:v>
                </c:pt>
                <c:pt idx="1">
                  <c:v>2.3334700000000002</c:v>
                </c:pt>
                <c:pt idx="2">
                  <c:v>3.3056000000000001</c:v>
                </c:pt>
                <c:pt idx="3">
                  <c:v>3.3056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7B45-41F8-9AAE-7EE943B80722}"/>
            </c:ext>
          </c:extLst>
        </c:ser>
        <c:ser>
          <c:idx val="24"/>
          <c:order val="24"/>
          <c:tx>
            <c:strRef>
              <c:f>'Patlak_10-88_cohort-C-S0020'!$A$257</c:f>
              <c:strCache>
                <c:ptCount val="1"/>
                <c:pt idx="0">
                  <c:v>Muscle (Reference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'Patlak_10-88_cohort-C-S0020'!$A$258:$A$277</c:f>
              <c:numCache>
                <c:formatCode>General</c:formatCode>
                <c:ptCount val="20"/>
                <c:pt idx="0">
                  <c:v>0</c:v>
                </c:pt>
                <c:pt idx="1">
                  <c:v>5.7735099999999999E-3</c:v>
                </c:pt>
                <c:pt idx="2">
                  <c:v>0.30271300000000001</c:v>
                </c:pt>
                <c:pt idx="3">
                  <c:v>0.93198300000000001</c:v>
                </c:pt>
                <c:pt idx="4">
                  <c:v>1.80775</c:v>
                </c:pt>
                <c:pt idx="5">
                  <c:v>2.5294699999999999</c:v>
                </c:pt>
                <c:pt idx="6">
                  <c:v>3.0411999999999999</c:v>
                </c:pt>
                <c:pt idx="7">
                  <c:v>3.4622299999999999</c:v>
                </c:pt>
                <c:pt idx="8">
                  <c:v>3.8586900000000002</c:v>
                </c:pt>
                <c:pt idx="9">
                  <c:v>4.6480100000000002</c:v>
                </c:pt>
                <c:pt idx="10">
                  <c:v>5.8669200000000004</c:v>
                </c:pt>
                <c:pt idx="11">
                  <c:v>8.1072500000000005</c:v>
                </c:pt>
                <c:pt idx="12">
                  <c:v>11.557499999999999</c:v>
                </c:pt>
                <c:pt idx="13">
                  <c:v>17.228400000000001</c:v>
                </c:pt>
                <c:pt idx="14">
                  <c:v>25.709599999999998</c:v>
                </c:pt>
                <c:pt idx="15">
                  <c:v>35.041600000000003</c:v>
                </c:pt>
                <c:pt idx="16">
                  <c:v>49.966900000000003</c:v>
                </c:pt>
                <c:pt idx="17">
                  <c:v>71.050600000000003</c:v>
                </c:pt>
                <c:pt idx="18">
                  <c:v>142.864</c:v>
                </c:pt>
                <c:pt idx="19">
                  <c:v>204.672</c:v>
                </c:pt>
              </c:numCache>
            </c:numRef>
          </c:xVal>
          <c:yVal>
            <c:numRef>
              <c:f>'Patlak_10-88_cohort-C-S0020'!$B$258:$B$277</c:f>
              <c:numCache>
                <c:formatCode>General</c:formatCode>
                <c:ptCount val="20"/>
                <c:pt idx="0">
                  <c:v>0</c:v>
                </c:pt>
                <c:pt idx="1">
                  <c:v>5.2853999999999998E-4</c:v>
                </c:pt>
                <c:pt idx="2">
                  <c:v>2.6405299999999999E-3</c:v>
                </c:pt>
                <c:pt idx="3">
                  <c:v>2.5810099999999999E-2</c:v>
                </c:pt>
                <c:pt idx="4">
                  <c:v>3.8832499999999999E-2</c:v>
                </c:pt>
                <c:pt idx="5">
                  <c:v>4.6790499999999999E-2</c:v>
                </c:pt>
                <c:pt idx="6">
                  <c:v>4.9760600000000002E-2</c:v>
                </c:pt>
                <c:pt idx="7">
                  <c:v>5.4080099999999999E-2</c:v>
                </c:pt>
                <c:pt idx="8">
                  <c:v>5.5849299999999998E-2</c:v>
                </c:pt>
                <c:pt idx="9">
                  <c:v>5.9108599999999997E-2</c:v>
                </c:pt>
                <c:pt idx="10">
                  <c:v>6.3768900000000003E-2</c:v>
                </c:pt>
                <c:pt idx="11">
                  <c:v>6.8877900000000006E-2</c:v>
                </c:pt>
                <c:pt idx="12">
                  <c:v>7.7172699999999997E-2</c:v>
                </c:pt>
                <c:pt idx="13">
                  <c:v>8.0399700000000004E-2</c:v>
                </c:pt>
                <c:pt idx="14">
                  <c:v>8.7692199999999998E-2</c:v>
                </c:pt>
                <c:pt idx="15">
                  <c:v>9.1690599999999997E-2</c:v>
                </c:pt>
                <c:pt idx="16">
                  <c:v>9.9754899999999994E-2</c:v>
                </c:pt>
                <c:pt idx="17">
                  <c:v>0.107221</c:v>
                </c:pt>
                <c:pt idx="18">
                  <c:v>0.13614399999999999</c:v>
                </c:pt>
                <c:pt idx="19">
                  <c:v>0.150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8-7B45-41F8-9AAE-7EE943B80722}"/>
            </c:ext>
          </c:extLst>
        </c:ser>
        <c:ser>
          <c:idx val="25"/>
          <c:order val="25"/>
          <c:tx>
            <c:v>Muscle 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xVal>
            <c:numRef>
              <c:f>'Patlak_10-88_cohort-C-S0020'!$E$258:$E$261</c:f>
              <c:numCache>
                <c:formatCode>General</c:formatCode>
                <c:ptCount val="4"/>
                <c:pt idx="0">
                  <c:v>0</c:v>
                </c:pt>
                <c:pt idx="1">
                  <c:v>142.864</c:v>
                </c:pt>
                <c:pt idx="2">
                  <c:v>204.672</c:v>
                </c:pt>
                <c:pt idx="3">
                  <c:v>204.672</c:v>
                </c:pt>
              </c:numCache>
            </c:numRef>
          </c:xVal>
          <c:yVal>
            <c:numRef>
              <c:f>'Patlak_10-88_cohort-C-S0020'!$F$258:$F$261</c:f>
              <c:numCache>
                <c:formatCode>General</c:formatCode>
                <c:ptCount val="4"/>
                <c:pt idx="0">
                  <c:v>7.6149800000000004E-2</c:v>
                </c:pt>
                <c:pt idx="1">
                  <c:v>0.13716500000000001</c:v>
                </c:pt>
                <c:pt idx="2">
                  <c:v>0.16356299999999999</c:v>
                </c:pt>
                <c:pt idx="3">
                  <c:v>0.163562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7B45-41F8-9AAE-7EE943B807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1347440"/>
        <c:axId val="401343912"/>
      </c:scatterChart>
      <c:valAx>
        <c:axId val="401347440"/>
        <c:scaling>
          <c:orientation val="minMax"/>
          <c:max val="20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Input Integral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01343912"/>
        <c:crosses val="autoZero"/>
        <c:crossBetween val="midCat"/>
        <c:majorUnit val="50"/>
      </c:valAx>
      <c:valAx>
        <c:axId val="401343912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400">
                    <a:solidFill>
                      <a:schemeClr val="tx1"/>
                    </a:solidFill>
                  </a:rPr>
                  <a:t>Tissue / Inpu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FI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01347440"/>
        <c:crosses val="autoZero"/>
        <c:crossBetween val="midCat"/>
        <c:majorUnit val="1"/>
      </c:valAx>
      <c:spPr>
        <a:noFill/>
        <a:ln>
          <a:noFill/>
        </a:ln>
        <a:effectLst/>
      </c:spPr>
    </c:plotArea>
    <c:legend>
      <c:legendPos val="r"/>
      <c:legendEntry>
        <c:idx val="1"/>
        <c:delete val="1"/>
      </c:legendEntry>
      <c:legendEntry>
        <c:idx val="3"/>
        <c:delete val="1"/>
      </c:legendEntry>
      <c:legendEntry>
        <c:idx val="5"/>
        <c:delete val="1"/>
      </c:legendEntry>
      <c:legendEntry>
        <c:idx val="7"/>
        <c:delete val="1"/>
      </c:legendEntry>
      <c:legendEntry>
        <c:idx val="9"/>
        <c:delete val="1"/>
      </c:legendEntry>
      <c:legendEntry>
        <c:idx val="11"/>
        <c:delete val="1"/>
      </c:legendEntry>
      <c:legendEntry>
        <c:idx val="13"/>
        <c:delete val="1"/>
      </c:legendEntry>
      <c:legendEntry>
        <c:idx val="15"/>
        <c:delete val="1"/>
      </c:legendEntry>
      <c:legendEntry>
        <c:idx val="17"/>
        <c:delete val="1"/>
      </c:legendEntry>
      <c:legendEntry>
        <c:idx val="19"/>
        <c:delete val="1"/>
      </c:legendEntry>
      <c:legendEntry>
        <c:idx val="21"/>
        <c:delete val="1"/>
      </c:legendEntry>
      <c:legendEntry>
        <c:idx val="22"/>
        <c:delete val="1"/>
      </c:legendEntry>
      <c:legendEntry>
        <c:idx val="23"/>
        <c:delete val="1"/>
      </c:legendEntry>
      <c:legendEntry>
        <c:idx val="25"/>
        <c:delete val="1"/>
      </c:legendEntry>
      <c:layout>
        <c:manualLayout>
          <c:xMode val="edge"/>
          <c:yMode val="edge"/>
          <c:x val="0.21570743021656646"/>
          <c:y val="1.6046647966236682E-2"/>
          <c:w val="0.2516576096883687"/>
          <c:h val="0.48076416526582477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7C6FF-8075-4BBC-8841-7E3331DC33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3152A1B-2395-4E76-B1FA-96F1382C96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175BE-CE08-4F6C-894B-32908A63A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4BE77-93B0-4131-A7DF-2F31EC68BE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072689-5DB7-4C8B-B149-3918D9BF4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7986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73F18B-AFAA-41F5-BA29-5D80DF775A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9E0A72-CC0B-4CE6-B90D-C07513D0E6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D1A4FD-9F43-4051-8818-4594BDEEC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95DF1-DFC6-4B16-9699-A5D0AA81F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A6384-BB30-49DB-9AC2-EA019614B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93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9C52A9-5888-4240-800C-29B560C360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950525-445F-45BC-86B4-18DA62AF5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97CDA6-2090-4ECE-80FE-9D2C99BE3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4076BE-282A-4D77-AF10-638394CDB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F5C8D-6DCB-4525-AF5E-8C70390D2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12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0B3B8E-9E8B-4FC8-AC4C-FD19FFC81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C6519F-32D0-4518-8501-C06A04D07A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CAC323-9309-4868-A9F1-E56F531D1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B5C00C-D02B-4C53-B2A9-263E4B5EA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98371-CBC4-45FD-8AD2-E7A82BBBE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84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B076B-7BC7-49EE-8D44-F2778D2A6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CDE742-7D16-4E02-BD03-803E00326A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A46F0D-9D01-4019-B50C-146478B9D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55E57C-E228-4C24-B0BE-5BC1E3DF0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1A049-3285-4D9D-9F42-DDB0362B2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989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7C4199-3FDB-4763-8C3C-CC6DEB348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72C4EA-9645-4FE2-9738-693D78F13F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52889D-B90D-4F95-BC4B-8085B1A12D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7E075E-5460-4A1B-8E9B-350334ECA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B6AB4C-AE51-4FF6-B4FE-B90B46B22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F34BE4-94E1-4937-84C9-16C516768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730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88DF7-6EF6-4858-BE3D-FF4FD1D67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6C83D4-0200-4505-8834-65F127C1BC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F4D545-CBD9-4F62-9223-A124E56EFE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B135E9-5C23-434D-B7C2-5C2BB804C7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EB0B6E-3C05-4AD5-930C-E6389F8308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BF357B-53BB-4E9D-A23D-BBAD0FFDF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3F25B3-4343-4D2D-A2FA-5B880C1F6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DF8947-F284-49DF-87AE-55354E1FA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999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50F8D0-6EC2-488B-AB91-18B595122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BB6CF6-2C0C-4682-B739-F0A041E61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9EA94C-58BD-4B48-8F49-0C3119829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FA1CF6-9427-42E1-811A-7693C28ED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5100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45409C-15F7-4FC1-BD69-C26F459FC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17F929-0AAD-491F-817E-A19FABF1C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E80AA7-83F7-4271-AF55-39DE28C3D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3524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3C070-269F-4F14-B92D-8AE51D744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6E2E22-9682-4EE6-809C-1B53AB7D23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28945D-8EB2-4179-9491-6FE533A4DE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8DBB0-262E-41E1-A1BF-A14B16F93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745EC2-9328-45D4-A3ED-DE9C4C057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238BBE-B417-4BDE-A24C-B3916120B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298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0F4B2-5841-4DC2-816E-55EBE90DA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991EE1-4626-4DE5-9A28-A82EDA359E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9B7557-E634-4C35-98C5-BB4042B9C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4101BA-20FF-4A67-9AC0-6980188C5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47AA8C-BA40-4656-B89E-1E4BE3D66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CC9AC-2082-486A-97E1-DBB1A9D04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990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587AD2-B99A-4104-AFE7-C648EB2032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0FD328-0FF9-4215-B042-7943B7A292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AA81F0-0E81-4F23-A8E7-7D3F18241B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DE829-091A-4E80-91E2-AB3DE6E2A63E}" type="datetimeFigureOut">
              <a:rPr lang="en-GB" smtClean="0"/>
              <a:t>27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34FDA2-4B5C-4A90-9855-8959DB5F8D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DA0808-6657-4591-8CE1-C917A2F510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5CC1B-F55F-4BA4-8DB6-7288D7FFEF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391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193A94CC-056C-4074-927C-0CD0587A1E1A}"/>
              </a:ext>
            </a:extLst>
          </p:cNvPr>
          <p:cNvSpPr/>
          <p:nvPr/>
        </p:nvSpPr>
        <p:spPr>
          <a:xfrm>
            <a:off x="477520" y="142875"/>
            <a:ext cx="11714480" cy="7092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6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line </a:t>
            </a:r>
            <a:r>
              <a:rPr lang="en-US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ource Figure 2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lak plots from data collected from dynamic and static imaging (118 minutes). Lines fitted to data collected between 10 and 118 minutes</a:t>
            </a:r>
            <a:endParaRPr lang="en-GB" b="1" dirty="0">
              <a:latin typeface="Times New Roman Bold" panose="020208030705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393458F8-C264-44A3-845F-408F2BA32C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3931944"/>
              </p:ext>
            </p:extLst>
          </p:nvPr>
        </p:nvGraphicFramePr>
        <p:xfrm>
          <a:off x="4032051" y="1160487"/>
          <a:ext cx="4407099" cy="3549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CF17AD2-5C02-4F8A-9473-2CB047DDBD4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3179473"/>
              </p:ext>
            </p:extLst>
          </p:nvPr>
        </p:nvGraphicFramePr>
        <p:xfrm>
          <a:off x="0" y="1160487"/>
          <a:ext cx="4318588" cy="3549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2548FE7-3AD2-4C07-A506-0D73BAA4C6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5616409"/>
              </p:ext>
            </p:extLst>
          </p:nvPr>
        </p:nvGraphicFramePr>
        <p:xfrm>
          <a:off x="7873414" y="1160487"/>
          <a:ext cx="4407099" cy="3549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E99BCFF0-3CD7-43D2-A46E-B076C2050D9E}"/>
              </a:ext>
            </a:extLst>
          </p:cNvPr>
          <p:cNvSpPr/>
          <p:nvPr/>
        </p:nvSpPr>
        <p:spPr>
          <a:xfrm>
            <a:off x="214629" y="5973738"/>
            <a:ext cx="11762740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inetic analysis and optimization of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8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-rhPSMA-7.3 PET imaging of prostate cancer. EJNMMI.</a:t>
            </a:r>
          </a:p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mona Malaspina, Vesa Oikonen, Anna Kuisma, Otto Ettala, Kalle Mattila, Peter J. </a:t>
            </a:r>
            <a:r>
              <a:rPr lang="en-GB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oström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Heikki Minn, Kari Kalliokoski, Ernst J. Postema, Matthew P. Miller, and Mika Scheinin.</a:t>
            </a:r>
          </a:p>
          <a:p>
            <a:pPr algn="just">
              <a:spcBef>
                <a:spcPts val="600"/>
              </a:spcBef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rresponding author: </a:t>
            </a: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imona Malaspina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simona.malaspina@tyks.fi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8C14A27-4900-461B-8C82-FA93387C6AFC}"/>
              </a:ext>
            </a:extLst>
          </p:cNvPr>
          <p:cNvSpPr/>
          <p:nvPr/>
        </p:nvSpPr>
        <p:spPr>
          <a:xfrm>
            <a:off x="409574" y="4880660"/>
            <a:ext cx="1156779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eft panel presents data from a patient in Cohort A, middle panel from a patient in Cohort B and right panel from a patient in Cohort C.</a:t>
            </a:r>
            <a:endParaRPr lang="en-GB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4671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</TotalTime>
  <Words>154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 Bold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rnbull Catriona</dc:creator>
  <cp:lastModifiedBy>Simona Malaspina</cp:lastModifiedBy>
  <cp:revision>10</cp:revision>
  <dcterms:created xsi:type="dcterms:W3CDTF">2020-12-16T11:49:07Z</dcterms:created>
  <dcterms:modified xsi:type="dcterms:W3CDTF">2021-03-27T16:43:46Z</dcterms:modified>
</cp:coreProperties>
</file>